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theme/themeOverride3.xml" ContentType="application/vnd.openxmlformats-officedocument.themeOverride+xml"/>
  <Override PartName="/ppt/charts/chart4.xml" ContentType="application/vnd.openxmlformats-officedocument.drawingml.chart+xml"/>
  <Override PartName="/ppt/theme/themeOverride4.xml" ContentType="application/vnd.openxmlformats-officedocument.themeOverride+xml"/>
  <Override PartName="/ppt/charts/chart5.xml" ContentType="application/vnd.openxmlformats-officedocument.drawingml.chart+xml"/>
  <Override PartName="/ppt/theme/themeOverride5.xml" ContentType="application/vnd.openxmlformats-officedocument.themeOverride+xml"/>
  <Override PartName="/ppt/charts/chart6.xml" ContentType="application/vnd.openxmlformats-officedocument.drawingml.chart+xml"/>
  <Override PartName="/ppt/theme/themeOverride6.xml" ContentType="application/vnd.openxmlformats-officedocument.themeOverride+xml"/>
  <Override PartName="/ppt/charts/chart7.xml" ContentType="application/vnd.openxmlformats-officedocument.drawingml.chart+xml"/>
  <Override PartName="/ppt/theme/themeOverride7.xml" ContentType="application/vnd.openxmlformats-officedocument.themeOverride+xml"/>
  <Override PartName="/ppt/charts/chart8.xml" ContentType="application/vnd.openxmlformats-officedocument.drawingml.chart+xml"/>
  <Override PartName="/ppt/theme/themeOverride8.xml" ContentType="application/vnd.openxmlformats-officedocument.themeOverride+xml"/>
  <Override PartName="/ppt/charts/chart9.xml" ContentType="application/vnd.openxmlformats-officedocument.drawingml.chart+xml"/>
  <Override PartName="/ppt/theme/themeOverride9.xml" ContentType="application/vnd.openxmlformats-officedocument.themeOverride+xml"/>
  <Override PartName="/ppt/charts/chart10.xml" ContentType="application/vnd.openxmlformats-officedocument.drawingml.chart+xml"/>
  <Override PartName="/ppt/theme/themeOverride10.xml" ContentType="application/vnd.openxmlformats-officedocument.themeOverride+xml"/>
  <Override PartName="/ppt/charts/chart11.xml" ContentType="application/vnd.openxmlformats-officedocument.drawingml.chart+xml"/>
  <Override PartName="/ppt/theme/themeOverride11.xml" ContentType="application/vnd.openxmlformats-officedocument.themeOverride+xml"/>
  <Override PartName="/ppt/charts/chart12.xml" ContentType="application/vnd.openxmlformats-officedocument.drawingml.chart+xml"/>
  <Override PartName="/ppt/theme/themeOverride12.xml" ContentType="application/vnd.openxmlformats-officedocument.themeOverride+xml"/>
  <Override PartName="/ppt/charts/chart13.xml" ContentType="application/vnd.openxmlformats-officedocument.drawingml.chart+xml"/>
  <Override PartName="/ppt/theme/themeOverride13.xml" ContentType="application/vnd.openxmlformats-officedocument.themeOverride+xml"/>
  <Override PartName="/ppt/charts/chart14.xml" ContentType="application/vnd.openxmlformats-officedocument.drawingml.chart+xml"/>
  <Override PartName="/ppt/theme/themeOverride14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98B954"/>
    <a:srgbClr val="46AAC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285" d="100"/>
          <a:sy n="285" d="100"/>
        </p:scale>
        <p:origin x="208" y="-8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1.xml"/><Relationship Id="rId2" Type="http://schemas.openxmlformats.org/officeDocument/2006/relationships/oleObject" Target="file:///C:\Users\mqbpjha4\AppData\Local\Microsoft\Windows\Temporary%20Internet%20Files\Content.Outlook\MAA158N1\Copy%2520of%2520paper%2520growth%2520curveS%25205%252010%252015%2520%25282%2529.xlsx" TargetMode="External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10.xml"/><Relationship Id="rId2" Type="http://schemas.openxmlformats.org/officeDocument/2006/relationships/oleObject" Target="file:///C:\Users\mqbpjha4\AppData\Local\Microsoft\Windows\Temporary%20Internet%20Files\Content.Outlook\MAA158N1\Copy%2520of%2520paper%2520growth%2520curveS%25205%252010%252015%2520%25282%2529.xlsx" TargetMode="External"/></Relationships>
</file>

<file path=ppt/charts/_rels/chart11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11.xml"/><Relationship Id="rId2" Type="http://schemas.openxmlformats.org/officeDocument/2006/relationships/oleObject" Target="file:///C:\Users\mqbpjha4\AppData\Local\Microsoft\Windows\Temporary%20Internet%20Files\Content.Outlook\MAA158N1\Copy%2520of%2520paper%2520growth%2520curveS%25205%252010%252015%2520%25282%2529.xlsx" TargetMode="External"/></Relationships>
</file>

<file path=ppt/charts/_rels/chart12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12.xml"/><Relationship Id="rId2" Type="http://schemas.openxmlformats.org/officeDocument/2006/relationships/oleObject" Target="file:///C:\Users\mqbpjha4\AppData\Local\Microsoft\Windows\Temporary%20Internet%20Files\Content.Outlook\MAA158N1\Copy%2520of%2520paper%2520growth%2520curveS%25205%252010%252015%2520%25282%2529.xlsx" TargetMode="External"/></Relationships>
</file>

<file path=ppt/charts/_rels/chart13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13.xml"/><Relationship Id="rId2" Type="http://schemas.openxmlformats.org/officeDocument/2006/relationships/oleObject" Target="file:///C:\Users\mqbpjha4\AppData\Local\Microsoft\Windows\Temporary%20Internet%20Files\Content.Outlook\MAA158N1\Copy%2520of%2520paper%2520growth%2520curveS%25205%252010%252015%2520%25282%2529.xlsx" TargetMode="External"/></Relationships>
</file>

<file path=ppt/charts/_rels/chart14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14.xml"/><Relationship Id="rId2" Type="http://schemas.openxmlformats.org/officeDocument/2006/relationships/oleObject" Target="file:///C:\Users\mqbpjha4\AppData\Local\Microsoft\Windows\Temporary%20Internet%20Files\Content.Outlook\MAA158N1\Copy%2520of%2520paper%2520growth%2520curveS%25205%252010%252015%2520%25282%2529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2.xml"/><Relationship Id="rId2" Type="http://schemas.openxmlformats.org/officeDocument/2006/relationships/oleObject" Target="file:///C:\Users\mqbpjha4\AppData\Local\Microsoft\Windows\Temporary%20Internet%20Files\Content.Outlook\MAA158N1\Copy%2520of%2520paper%2520growth%2520curveS%25205%252010%252015%2520%25282%2529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3.xml"/><Relationship Id="rId2" Type="http://schemas.openxmlformats.org/officeDocument/2006/relationships/oleObject" Target="file:///C:\Users\mqbpjha4\AppData\Local\Microsoft\Windows\Temporary%20Internet%20Files\Content.Outlook\MAA158N1\Copy%2520of%2520paper%2520growth%2520curveS%25205%252010%252015%2520%25282%2529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4.xml"/><Relationship Id="rId2" Type="http://schemas.openxmlformats.org/officeDocument/2006/relationships/oleObject" Target="file:///C:\Users\mqbpjha4\AppData\Local\Microsoft\Windows\Temporary%20Internet%20Files\Content.Outlook\MAA158N1\Copy%2520of%2520paper%2520growth%2520curveS%25205%252010%252015%2520%25282%2529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5.xml"/><Relationship Id="rId2" Type="http://schemas.openxmlformats.org/officeDocument/2006/relationships/oleObject" Target="file:///C:\Users\mqbpjha4\AppData\Local\Microsoft\Windows\Temporary%20Internet%20Files\Content.Outlook\MAA158N1\Copy%2520of%2520paper%2520growth%2520curveS%25205%252010%252015%2520%25282%2529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6.xml"/><Relationship Id="rId2" Type="http://schemas.openxmlformats.org/officeDocument/2006/relationships/oleObject" Target="file:///C:\Users\mqbpjha4\AppData\Local\Microsoft\Windows\Temporary%20Internet%20Files\Content.Outlook\MAA158N1\Copy%2520of%2520paper%2520growth%2520curveS%25205%252010%252015%2520%25282%2529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7.xml"/><Relationship Id="rId2" Type="http://schemas.openxmlformats.org/officeDocument/2006/relationships/oleObject" Target="file:///C:\Users\mqbpjha4\AppData\Local\Microsoft\Windows\Temporary%20Internet%20Files\Content.Outlook\MAA158N1\Copy%2520of%2520paper%2520growth%2520curveS%25205%252010%252015%2520%25282%2529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8.xml"/><Relationship Id="rId2" Type="http://schemas.openxmlformats.org/officeDocument/2006/relationships/oleObject" Target="file:///C:\Users\mqbpjha4\AppData\Local\Microsoft\Windows\Temporary%20Internet%20Files\Content.Outlook\MAA158N1\Copy%2520of%2520paper%2520growth%2520curveS%25205%252010%252015%2520%25282%2529.xlsx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9.xml"/><Relationship Id="rId2" Type="http://schemas.openxmlformats.org/officeDocument/2006/relationships/oleObject" Target="file:///C:\Users\mqbpjha4\AppData\Local\Microsoft\Windows\Temporary%20Internet%20Files\Content.Outlook\MAA158N1\Copy%2520of%2520paper%2520growth%2520curveS%25205%252010%252015%2520%25282%2529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24236017834861"/>
          <c:y val="0.14750167523216"/>
          <c:w val="0.560208369610218"/>
          <c:h val="0.652451159433211"/>
        </c:manualLayout>
      </c:layout>
      <c:lineChart>
        <c:grouping val="standard"/>
        <c:varyColors val="0"/>
        <c:ser>
          <c:idx val="4"/>
          <c:order val="0"/>
          <c:tx>
            <c:strRef>
              <c:f>'Reems - growth rate data'!$B$11</c:f>
              <c:strCache>
                <c:ptCount val="1"/>
                <c:pt idx="0">
                  <c:v>adh1.ALD6.ACS2.BUTR+5g</c:v>
                </c:pt>
              </c:strCache>
            </c:strRef>
          </c:tx>
          <c:spPr>
            <a:ln w="12700">
              <a:solidFill>
                <a:srgbClr val="98B954"/>
              </a:solidFill>
            </a:ln>
          </c:spPr>
          <c:marker>
            <c:symbol val="triangle"/>
            <c:size val="3"/>
            <c:spPr>
              <a:solidFill>
                <a:srgbClr val="98B954"/>
              </a:solidFill>
              <a:ln>
                <a:solidFill>
                  <a:srgbClr val="98B954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Reems - growth rate data'!$C$23:$K$23</c:f>
                <c:numCache>
                  <c:formatCode>General</c:formatCode>
                  <c:ptCount val="9"/>
                  <c:pt idx="0">
                    <c:v>0.0126622799421484</c:v>
                  </c:pt>
                  <c:pt idx="1">
                    <c:v>0.0432935715012441</c:v>
                  </c:pt>
                  <c:pt idx="2">
                    <c:v>0.0381881307912987</c:v>
                  </c:pt>
                  <c:pt idx="3">
                    <c:v>0.0383014360044111</c:v>
                  </c:pt>
                  <c:pt idx="4">
                    <c:v>0.0398873413503582</c:v>
                  </c:pt>
                  <c:pt idx="5">
                    <c:v>0.0433128156554155</c:v>
                  </c:pt>
                  <c:pt idx="6">
                    <c:v>0.0427823951332009</c:v>
                  </c:pt>
                  <c:pt idx="7">
                    <c:v>0.031224989991992</c:v>
                  </c:pt>
                  <c:pt idx="8">
                    <c:v>0.0334713808100791</c:v>
                  </c:pt>
                </c:numCache>
              </c:numRef>
            </c:plus>
            <c:minus>
              <c:numRef>
                <c:f>'Reems - growth rate data'!$C$23:$K$23</c:f>
                <c:numCache>
                  <c:formatCode>General</c:formatCode>
                  <c:ptCount val="9"/>
                  <c:pt idx="0">
                    <c:v>0.0126622799421484</c:v>
                  </c:pt>
                  <c:pt idx="1">
                    <c:v>0.0432935715012441</c:v>
                  </c:pt>
                  <c:pt idx="2">
                    <c:v>0.0381881307912987</c:v>
                  </c:pt>
                  <c:pt idx="3">
                    <c:v>0.0383014360044111</c:v>
                  </c:pt>
                  <c:pt idx="4">
                    <c:v>0.0398873413503582</c:v>
                  </c:pt>
                  <c:pt idx="5">
                    <c:v>0.0433128156554155</c:v>
                  </c:pt>
                  <c:pt idx="6">
                    <c:v>0.0427823951332009</c:v>
                  </c:pt>
                  <c:pt idx="7">
                    <c:v>0.031224989991992</c:v>
                  </c:pt>
                  <c:pt idx="8">
                    <c:v>0.0334713808100791</c:v>
                  </c:pt>
                </c:numCache>
              </c:numRef>
            </c:minus>
          </c:errBars>
          <c:cat>
            <c:numRef>
              <c:f>'Reems - growth rate data'!$C$6:$K$6</c:f>
              <c:numCache>
                <c:formatCode>General</c:formatCode>
                <c:ptCount val="9"/>
                <c:pt idx="0">
                  <c:v>0.0</c:v>
                </c:pt>
                <c:pt idx="1">
                  <c:v>4.0</c:v>
                </c:pt>
                <c:pt idx="2">
                  <c:v>7.0</c:v>
                </c:pt>
                <c:pt idx="3">
                  <c:v>9.0</c:v>
                </c:pt>
                <c:pt idx="4">
                  <c:v>11.0</c:v>
                </c:pt>
                <c:pt idx="5">
                  <c:v>13.0</c:v>
                </c:pt>
                <c:pt idx="6">
                  <c:v>15.0</c:v>
                </c:pt>
                <c:pt idx="7">
                  <c:v>17.0</c:v>
                </c:pt>
                <c:pt idx="8">
                  <c:v>21.0</c:v>
                </c:pt>
              </c:numCache>
            </c:numRef>
          </c:cat>
          <c:val>
            <c:numRef>
              <c:f>'Reems - growth rate data'!$C$11:$K$11</c:f>
              <c:numCache>
                <c:formatCode>General</c:formatCode>
                <c:ptCount val="9"/>
                <c:pt idx="0">
                  <c:v>0.116666666666667</c:v>
                </c:pt>
                <c:pt idx="1">
                  <c:v>0.583666666666667</c:v>
                </c:pt>
                <c:pt idx="2">
                  <c:v>0.520333333333333</c:v>
                </c:pt>
                <c:pt idx="3">
                  <c:v>0.522</c:v>
                </c:pt>
                <c:pt idx="4">
                  <c:v>0.527</c:v>
                </c:pt>
                <c:pt idx="5">
                  <c:v>0.504</c:v>
                </c:pt>
                <c:pt idx="6">
                  <c:v>0.481666666666667</c:v>
                </c:pt>
                <c:pt idx="7">
                  <c:v>0.492</c:v>
                </c:pt>
                <c:pt idx="8">
                  <c:v>0.471333333333333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-2084724504"/>
        <c:axId val="-2085344248"/>
      </c:lineChart>
      <c:dateAx>
        <c:axId val="-208472450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-2085344248"/>
        <c:crosses val="autoZero"/>
        <c:auto val="0"/>
        <c:lblOffset val="100"/>
        <c:baseTimeUnit val="days"/>
        <c:majorUnit val="3.0"/>
        <c:majorTimeUnit val="days"/>
      </c:dateAx>
      <c:valAx>
        <c:axId val="-2085344248"/>
        <c:scaling>
          <c:orientation val="minMax"/>
          <c:max val="4.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-2084724504"/>
        <c:crosses val="autoZero"/>
        <c:crossBetween val="midCat"/>
      </c:valAx>
    </c:plotArea>
    <c:plotVisOnly val="1"/>
    <c:dispBlanksAs val="gap"/>
    <c:showDLblsOverMax val="0"/>
  </c:chart>
  <c:externalData r:id="rId2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86523760238582"/>
          <c:y val="0.169616322647893"/>
          <c:w val="0.525170793272222"/>
          <c:h val="0.648239820271414"/>
        </c:manualLayout>
      </c:layout>
      <c:scatterChart>
        <c:scatterStyle val="lineMarker"/>
        <c:varyColors val="0"/>
        <c:ser>
          <c:idx val="1"/>
          <c:order val="0"/>
          <c:tx>
            <c:strRef>
              <c:f>'Glucose assay data'!$A$4</c:f>
              <c:strCache>
                <c:ptCount val="1"/>
                <c:pt idx="0">
                  <c:v>BUT S+ 5g</c:v>
                </c:pt>
              </c:strCache>
            </c:strRef>
          </c:tx>
          <c:spPr>
            <a:ln w="12700"/>
          </c:spPr>
          <c:marker>
            <c:symbol val="square"/>
            <c:size val="3"/>
          </c:marker>
          <c:errBars>
            <c:errDir val="y"/>
            <c:errBarType val="both"/>
            <c:errValType val="cust"/>
            <c:noEndCap val="0"/>
            <c:plus>
              <c:numRef>
                <c:f>'Glucose assay data'!$B$12:$H$12</c:f>
                <c:numCache>
                  <c:formatCode>General</c:formatCode>
                  <c:ptCount val="7"/>
                  <c:pt idx="0">
                    <c:v>0.0147308424670602</c:v>
                  </c:pt>
                  <c:pt idx="1">
                    <c:v>0.149192603332303</c:v>
                  </c:pt>
                  <c:pt idx="2">
                    <c:v>0.00132093153895879</c:v>
                  </c:pt>
                  <c:pt idx="3">
                    <c:v>0.000821894236676078</c:v>
                  </c:pt>
                  <c:pt idx="4">
                    <c:v>0.0302838268413493</c:v>
                  </c:pt>
                  <c:pt idx="5">
                    <c:v>0.0423464539284855</c:v>
                  </c:pt>
                  <c:pt idx="6">
                    <c:v>0.0020136428165477</c:v>
                  </c:pt>
                </c:numCache>
              </c:numRef>
            </c:plus>
            <c:minus>
              <c:numRef>
                <c:f>'Glucose assay data'!$B$12:$H$12</c:f>
                <c:numCache>
                  <c:formatCode>General</c:formatCode>
                  <c:ptCount val="7"/>
                  <c:pt idx="0">
                    <c:v>0.0147308424670602</c:v>
                  </c:pt>
                  <c:pt idx="1">
                    <c:v>0.149192603332303</c:v>
                  </c:pt>
                  <c:pt idx="2">
                    <c:v>0.00132093153895879</c:v>
                  </c:pt>
                  <c:pt idx="3">
                    <c:v>0.000821894236676078</c:v>
                  </c:pt>
                  <c:pt idx="4">
                    <c:v>0.0302838268413493</c:v>
                  </c:pt>
                  <c:pt idx="5">
                    <c:v>0.0423464539284855</c:v>
                  </c:pt>
                  <c:pt idx="6">
                    <c:v>0.0020136428165477</c:v>
                  </c:pt>
                </c:numCache>
              </c:numRef>
            </c:minus>
          </c:errBars>
          <c:xVal>
            <c:numRef>
              <c:f>'Glucose assay data'!$B$2:$H$2</c:f>
              <c:numCache>
                <c:formatCode>General</c:formatCode>
                <c:ptCount val="7"/>
                <c:pt idx="0">
                  <c:v>0.0</c:v>
                </c:pt>
                <c:pt idx="1">
                  <c:v>2.0</c:v>
                </c:pt>
                <c:pt idx="2">
                  <c:v>4.0</c:v>
                </c:pt>
                <c:pt idx="3">
                  <c:v>7.0</c:v>
                </c:pt>
                <c:pt idx="4">
                  <c:v>9.0</c:v>
                </c:pt>
                <c:pt idx="5">
                  <c:v>11.0</c:v>
                </c:pt>
                <c:pt idx="6">
                  <c:v>21.0</c:v>
                </c:pt>
              </c:numCache>
            </c:numRef>
          </c:xVal>
          <c:yVal>
            <c:numRef>
              <c:f>'Glucose assay data'!$B$4:$H$4</c:f>
              <c:numCache>
                <c:formatCode>General</c:formatCode>
                <c:ptCount val="7"/>
                <c:pt idx="0">
                  <c:v>100.0</c:v>
                </c:pt>
                <c:pt idx="1">
                  <c:v>2.025618031129663</c:v>
                </c:pt>
                <c:pt idx="2">
                  <c:v>0.0558161281122904</c:v>
                </c:pt>
                <c:pt idx="3">
                  <c:v>0.0625140634857652</c:v>
                </c:pt>
                <c:pt idx="4">
                  <c:v>0.453700334495062</c:v>
                </c:pt>
                <c:pt idx="5">
                  <c:v>0.402758898828451</c:v>
                </c:pt>
                <c:pt idx="6">
                  <c:v>0.0706201901312811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082999944"/>
        <c:axId val="-2085796616"/>
      </c:scatterChart>
      <c:valAx>
        <c:axId val="-2082999944"/>
        <c:scaling>
          <c:orientation val="minMax"/>
          <c:max val="21.0"/>
          <c:min val="0.0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-2085796616"/>
        <c:crosses val="autoZero"/>
        <c:crossBetween val="midCat"/>
        <c:majorUnit val="3.0"/>
        <c:minorUnit val="0.6"/>
      </c:valAx>
      <c:valAx>
        <c:axId val="-2085796616"/>
        <c:scaling>
          <c:orientation val="minMax"/>
          <c:max val="100.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-2082999944"/>
        <c:crosses val="autoZero"/>
        <c:crossBetween val="midCat"/>
      </c:valAx>
      <c:spPr>
        <a:noFill/>
        <a:ln w="25400">
          <a:noFill/>
        </a:ln>
      </c:spPr>
    </c:plotArea>
    <c:plotVisOnly val="1"/>
    <c:dispBlanksAs val="gap"/>
    <c:showDLblsOverMax val="0"/>
  </c:chart>
  <c:externalData r:id="rId2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0484268353258"/>
          <c:y val="0.181076741820278"/>
          <c:w val="0.525170793272222"/>
          <c:h val="0.648579913489272"/>
        </c:manualLayout>
      </c:layout>
      <c:scatterChart>
        <c:scatterStyle val="lineMarker"/>
        <c:varyColors val="0"/>
        <c:ser>
          <c:idx val="0"/>
          <c:order val="0"/>
          <c:tx>
            <c:strRef>
              <c:f>'Glucose assay data'!$A$3</c:f>
              <c:strCache>
                <c:ptCount val="1"/>
                <c:pt idx="0">
                  <c:v>BUTR+5g</c:v>
                </c:pt>
              </c:strCache>
            </c:strRef>
          </c:tx>
          <c:marker>
            <c:symbol val="diamond"/>
            <c:size val="3"/>
          </c:marker>
          <c:dPt>
            <c:idx val="1"/>
            <c:bubble3D val="0"/>
            <c:spPr>
              <a:ln w="12700"/>
            </c:spPr>
          </c:dPt>
          <c:errBars>
            <c:errDir val="y"/>
            <c:errBarType val="both"/>
            <c:errValType val="cust"/>
            <c:noEndCap val="0"/>
            <c:plus>
              <c:numRef>
                <c:f>'Glucose assay data'!$B$11:$H$11</c:f>
                <c:numCache>
                  <c:formatCode>General</c:formatCode>
                  <c:ptCount val="7"/>
                  <c:pt idx="0">
                    <c:v>0.042035478260274</c:v>
                  </c:pt>
                  <c:pt idx="1">
                    <c:v>0.092185772401705</c:v>
                  </c:pt>
                  <c:pt idx="2">
                    <c:v>0.0271308258146895</c:v>
                  </c:pt>
                  <c:pt idx="3">
                    <c:v>0.00199143611776962</c:v>
                  </c:pt>
                  <c:pt idx="4">
                    <c:v>0.159473549763883</c:v>
                  </c:pt>
                  <c:pt idx="5">
                    <c:v>0.0884531005998728</c:v>
                  </c:pt>
                  <c:pt idx="6">
                    <c:v>0.000728075840672507</c:v>
                  </c:pt>
                </c:numCache>
              </c:numRef>
            </c:plus>
            <c:minus>
              <c:numRef>
                <c:f>'Glucose assay data'!$B$11:$H$11</c:f>
                <c:numCache>
                  <c:formatCode>General</c:formatCode>
                  <c:ptCount val="7"/>
                  <c:pt idx="0">
                    <c:v>0.042035478260274</c:v>
                  </c:pt>
                  <c:pt idx="1">
                    <c:v>0.092185772401705</c:v>
                  </c:pt>
                  <c:pt idx="2">
                    <c:v>0.0271308258146895</c:v>
                  </c:pt>
                  <c:pt idx="3">
                    <c:v>0.00199143611776962</c:v>
                  </c:pt>
                  <c:pt idx="4">
                    <c:v>0.159473549763883</c:v>
                  </c:pt>
                  <c:pt idx="5">
                    <c:v>0.0884531005998728</c:v>
                  </c:pt>
                  <c:pt idx="6">
                    <c:v>0.000728075840672507</c:v>
                  </c:pt>
                </c:numCache>
              </c:numRef>
            </c:minus>
          </c:errBars>
          <c:xVal>
            <c:numRef>
              <c:f>'Glucose assay data'!$B$2:$H$2</c:f>
              <c:numCache>
                <c:formatCode>General</c:formatCode>
                <c:ptCount val="7"/>
                <c:pt idx="0">
                  <c:v>0.0</c:v>
                </c:pt>
                <c:pt idx="1">
                  <c:v>2.0</c:v>
                </c:pt>
                <c:pt idx="2">
                  <c:v>4.0</c:v>
                </c:pt>
                <c:pt idx="3">
                  <c:v>7.0</c:v>
                </c:pt>
                <c:pt idx="4">
                  <c:v>9.0</c:v>
                </c:pt>
                <c:pt idx="5">
                  <c:v>11.0</c:v>
                </c:pt>
                <c:pt idx="6">
                  <c:v>21.0</c:v>
                </c:pt>
              </c:numCache>
            </c:numRef>
          </c:xVal>
          <c:yVal>
            <c:numRef>
              <c:f>'Glucose assay data'!$B$3:$H$3</c:f>
              <c:numCache>
                <c:formatCode>General</c:formatCode>
                <c:ptCount val="7"/>
                <c:pt idx="0">
                  <c:v>100.0</c:v>
                </c:pt>
                <c:pt idx="1">
                  <c:v>1.469560546094797</c:v>
                </c:pt>
                <c:pt idx="2">
                  <c:v>0.0968392479423881</c:v>
                </c:pt>
                <c:pt idx="3">
                  <c:v>0.0674879707309839</c:v>
                </c:pt>
                <c:pt idx="4">
                  <c:v>0.811509763539007</c:v>
                </c:pt>
                <c:pt idx="5">
                  <c:v>0.386426775904085</c:v>
                </c:pt>
                <c:pt idx="6">
                  <c:v>0.0708082832331329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087454728"/>
        <c:axId val="-2100671320"/>
      </c:scatterChart>
      <c:valAx>
        <c:axId val="-2087454728"/>
        <c:scaling>
          <c:orientation val="minMax"/>
          <c:max val="21.0"/>
          <c:min val="0.0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-2100671320"/>
        <c:crosses val="autoZero"/>
        <c:crossBetween val="midCat"/>
        <c:majorUnit val="3.0"/>
        <c:minorUnit val="0.6"/>
      </c:valAx>
      <c:valAx>
        <c:axId val="-2100671320"/>
        <c:scaling>
          <c:orientation val="minMax"/>
          <c:max val="100.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-2087454728"/>
        <c:crosses val="autoZero"/>
        <c:crossBetween val="midCat"/>
      </c:valAx>
    </c:plotArea>
    <c:plotVisOnly val="1"/>
    <c:dispBlanksAs val="gap"/>
    <c:showDLblsOverMax val="0"/>
  </c:chart>
  <c:externalData r:id="rId2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0913959489116673"/>
          <c:y val="0.212457032791696"/>
          <c:w val="0.525170793272222"/>
          <c:h val="0.648239820271414"/>
        </c:manualLayout>
      </c:layout>
      <c:scatterChart>
        <c:scatterStyle val="lineMarker"/>
        <c:varyColors val="0"/>
        <c:ser>
          <c:idx val="2"/>
          <c:order val="0"/>
          <c:tx>
            <c:strRef>
              <c:f>'Glucose assay data'!$A$5</c:f>
              <c:strCache>
                <c:ptCount val="1"/>
                <c:pt idx="0">
                  <c:v>adh1.ALD6.ACS2.BUTR+5g</c:v>
                </c:pt>
              </c:strCache>
            </c:strRef>
          </c:tx>
          <c:spPr>
            <a:ln w="12700"/>
          </c:spPr>
          <c:marker>
            <c:symbol val="triangle"/>
            <c:size val="3"/>
          </c:marker>
          <c:errBars>
            <c:errDir val="y"/>
            <c:errBarType val="both"/>
            <c:errValType val="cust"/>
            <c:noEndCap val="0"/>
            <c:plus>
              <c:numRef>
                <c:f>'Glucose assay data'!$B$13:$H$13</c:f>
                <c:numCache>
                  <c:formatCode>General</c:formatCode>
                  <c:ptCount val="7"/>
                  <c:pt idx="0">
                    <c:v>0.562341246114409</c:v>
                  </c:pt>
                  <c:pt idx="1">
                    <c:v>2.44119237600793</c:v>
                  </c:pt>
                  <c:pt idx="2">
                    <c:v>1.267297930219603</c:v>
                  </c:pt>
                  <c:pt idx="3">
                    <c:v>1.012660958329656</c:v>
                  </c:pt>
                  <c:pt idx="4">
                    <c:v>0.910534060176255</c:v>
                  </c:pt>
                  <c:pt idx="5">
                    <c:v>0.830271263992583</c:v>
                  </c:pt>
                  <c:pt idx="6">
                    <c:v>0.919344502296786</c:v>
                  </c:pt>
                </c:numCache>
              </c:numRef>
            </c:plus>
            <c:minus>
              <c:numRef>
                <c:f>'Glucose assay data'!$B$13:$H$13</c:f>
                <c:numCache>
                  <c:formatCode>General</c:formatCode>
                  <c:ptCount val="7"/>
                  <c:pt idx="0">
                    <c:v>0.562341246114409</c:v>
                  </c:pt>
                  <c:pt idx="1">
                    <c:v>2.44119237600793</c:v>
                  </c:pt>
                  <c:pt idx="2">
                    <c:v>1.267297930219603</c:v>
                  </c:pt>
                  <c:pt idx="3">
                    <c:v>1.012660958329656</c:v>
                  </c:pt>
                  <c:pt idx="4">
                    <c:v>0.910534060176255</c:v>
                  </c:pt>
                  <c:pt idx="5">
                    <c:v>0.830271263992583</c:v>
                  </c:pt>
                  <c:pt idx="6">
                    <c:v>0.919344502296786</c:v>
                  </c:pt>
                </c:numCache>
              </c:numRef>
            </c:minus>
          </c:errBars>
          <c:xVal>
            <c:numRef>
              <c:f>'Glucose assay data'!$B$2:$H$2</c:f>
              <c:numCache>
                <c:formatCode>General</c:formatCode>
                <c:ptCount val="7"/>
                <c:pt idx="0">
                  <c:v>0.0</c:v>
                </c:pt>
                <c:pt idx="1">
                  <c:v>2.0</c:v>
                </c:pt>
                <c:pt idx="2">
                  <c:v>4.0</c:v>
                </c:pt>
                <c:pt idx="3">
                  <c:v>7.0</c:v>
                </c:pt>
                <c:pt idx="4">
                  <c:v>9.0</c:v>
                </c:pt>
                <c:pt idx="5">
                  <c:v>11.0</c:v>
                </c:pt>
                <c:pt idx="6">
                  <c:v>21.0</c:v>
                </c:pt>
              </c:numCache>
            </c:numRef>
          </c:xVal>
          <c:yVal>
            <c:numRef>
              <c:f>'Glucose assay data'!$B$5:$H$5</c:f>
              <c:numCache>
                <c:formatCode>General</c:formatCode>
                <c:ptCount val="7"/>
                <c:pt idx="0">
                  <c:v>100.0</c:v>
                </c:pt>
                <c:pt idx="1">
                  <c:v>61.38784655952003</c:v>
                </c:pt>
                <c:pt idx="2">
                  <c:v>8.364207327588326</c:v>
                </c:pt>
                <c:pt idx="3">
                  <c:v>2.963204136271967</c:v>
                </c:pt>
                <c:pt idx="4">
                  <c:v>2.263790632342665</c:v>
                </c:pt>
                <c:pt idx="5">
                  <c:v>2.101268869845334</c:v>
                </c:pt>
                <c:pt idx="6">
                  <c:v>1.940621843080031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008654760"/>
        <c:axId val="-2008651736"/>
      </c:scatterChart>
      <c:valAx>
        <c:axId val="-2008654760"/>
        <c:scaling>
          <c:orientation val="minMax"/>
          <c:max val="21.0"/>
          <c:min val="0.0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-2008651736"/>
        <c:crosses val="autoZero"/>
        <c:crossBetween val="midCat"/>
        <c:majorUnit val="3.0"/>
        <c:minorUnit val="0.6"/>
      </c:valAx>
      <c:valAx>
        <c:axId val="-2008651736"/>
        <c:scaling>
          <c:orientation val="minMax"/>
          <c:max val="100.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-2008654760"/>
        <c:crosses val="autoZero"/>
        <c:crossBetween val="midCat"/>
      </c:valAx>
    </c:plotArea>
    <c:plotVisOnly val="1"/>
    <c:dispBlanksAs val="gap"/>
    <c:showDLblsOverMax val="0"/>
  </c:chart>
  <c:externalData r:id="rId2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24236017834861"/>
          <c:y val="0.14750167523216"/>
          <c:w val="0.560208369610218"/>
          <c:h val="0.652451159433211"/>
        </c:manualLayout>
      </c:layout>
      <c:lineChart>
        <c:grouping val="standard"/>
        <c:varyColors val="0"/>
        <c:ser>
          <c:idx val="5"/>
          <c:order val="0"/>
          <c:tx>
            <c:strRef>
              <c:f>'Reems - growth rate data'!$B$12</c:f>
              <c:strCache>
                <c:ptCount val="1"/>
                <c:pt idx="0">
                  <c:v>adh1.ALD6.ACS2.BUTS+5g</c:v>
                </c:pt>
              </c:strCache>
            </c:strRef>
          </c:tx>
          <c:marker>
            <c:symbol val="circle"/>
            <c:size val="3"/>
          </c:marker>
          <c:dPt>
            <c:idx val="1"/>
            <c:bubble3D val="0"/>
            <c:spPr>
              <a:ln w="12700"/>
            </c:spPr>
          </c:dPt>
          <c:dPt>
            <c:idx val="2"/>
            <c:bubble3D val="0"/>
            <c:spPr>
              <a:ln w="12700"/>
            </c:spPr>
          </c:dPt>
          <c:dPt>
            <c:idx val="3"/>
            <c:bubble3D val="0"/>
            <c:spPr>
              <a:ln w="12700"/>
            </c:spPr>
          </c:dPt>
          <c:dPt>
            <c:idx val="4"/>
            <c:bubble3D val="0"/>
            <c:spPr>
              <a:ln w="12700"/>
            </c:spPr>
          </c:dPt>
          <c:dPt>
            <c:idx val="5"/>
            <c:bubble3D val="0"/>
            <c:spPr>
              <a:ln w="12700"/>
            </c:spPr>
          </c:dPt>
          <c:dPt>
            <c:idx val="6"/>
            <c:bubble3D val="0"/>
            <c:spPr>
              <a:ln w="12700"/>
            </c:spPr>
          </c:dPt>
          <c:dPt>
            <c:idx val="7"/>
            <c:bubble3D val="0"/>
            <c:spPr>
              <a:ln w="12700"/>
            </c:spPr>
          </c:dPt>
          <c:dPt>
            <c:idx val="8"/>
            <c:bubble3D val="0"/>
            <c:spPr>
              <a:ln w="12700"/>
            </c:spPr>
          </c:dPt>
          <c:errBars>
            <c:errDir val="y"/>
            <c:errBarType val="both"/>
            <c:errValType val="cust"/>
            <c:noEndCap val="0"/>
            <c:plus>
              <c:numRef>
                <c:f>'Reems - growth rate data'!$C$24:$K$24</c:f>
                <c:numCache>
                  <c:formatCode>General</c:formatCode>
                  <c:ptCount val="9"/>
                  <c:pt idx="0">
                    <c:v>0.00929157324317757</c:v>
                  </c:pt>
                  <c:pt idx="1">
                    <c:v>0.140535879167326</c:v>
                  </c:pt>
                  <c:pt idx="2">
                    <c:v>0.132500314465036</c:v>
                  </c:pt>
                  <c:pt idx="3">
                    <c:v>0.140684043160552</c:v>
                  </c:pt>
                  <c:pt idx="4">
                    <c:v>0.153493756659134</c:v>
                  </c:pt>
                  <c:pt idx="5">
                    <c:v>0.154862304429882</c:v>
                  </c:pt>
                  <c:pt idx="6">
                    <c:v>0.153004357236431</c:v>
                  </c:pt>
                  <c:pt idx="7">
                    <c:v>0.14871449156017</c:v>
                  </c:pt>
                  <c:pt idx="8">
                    <c:v>0.140385184403483</c:v>
                  </c:pt>
                </c:numCache>
              </c:numRef>
            </c:plus>
            <c:minus>
              <c:numRef>
                <c:f>'Reems - growth rate data'!$C$24:$K$24</c:f>
                <c:numCache>
                  <c:formatCode>General</c:formatCode>
                  <c:ptCount val="9"/>
                  <c:pt idx="0">
                    <c:v>0.00929157324317757</c:v>
                  </c:pt>
                  <c:pt idx="1">
                    <c:v>0.140535879167326</c:v>
                  </c:pt>
                  <c:pt idx="2">
                    <c:v>0.132500314465036</c:v>
                  </c:pt>
                  <c:pt idx="3">
                    <c:v>0.140684043160552</c:v>
                  </c:pt>
                  <c:pt idx="4">
                    <c:v>0.153493756659134</c:v>
                  </c:pt>
                  <c:pt idx="5">
                    <c:v>0.154862304429882</c:v>
                  </c:pt>
                  <c:pt idx="6">
                    <c:v>0.153004357236431</c:v>
                  </c:pt>
                  <c:pt idx="7">
                    <c:v>0.14871449156017</c:v>
                  </c:pt>
                  <c:pt idx="8">
                    <c:v>0.140385184403483</c:v>
                  </c:pt>
                </c:numCache>
              </c:numRef>
            </c:minus>
          </c:errBars>
          <c:cat>
            <c:numRef>
              <c:f>'Reems - growth rate data'!$C$6:$K$6</c:f>
              <c:numCache>
                <c:formatCode>General</c:formatCode>
                <c:ptCount val="9"/>
                <c:pt idx="0">
                  <c:v>0.0</c:v>
                </c:pt>
                <c:pt idx="1">
                  <c:v>4.0</c:v>
                </c:pt>
                <c:pt idx="2">
                  <c:v>7.0</c:v>
                </c:pt>
                <c:pt idx="3">
                  <c:v>9.0</c:v>
                </c:pt>
                <c:pt idx="4">
                  <c:v>11.0</c:v>
                </c:pt>
                <c:pt idx="5">
                  <c:v>13.0</c:v>
                </c:pt>
                <c:pt idx="6">
                  <c:v>15.0</c:v>
                </c:pt>
                <c:pt idx="7">
                  <c:v>17.0</c:v>
                </c:pt>
                <c:pt idx="8">
                  <c:v>21.0</c:v>
                </c:pt>
              </c:numCache>
            </c:numRef>
          </c:cat>
          <c:val>
            <c:numRef>
              <c:f>'Reems - growth rate data'!$C$12:$K$12</c:f>
              <c:numCache>
                <c:formatCode>General</c:formatCode>
                <c:ptCount val="9"/>
                <c:pt idx="0">
                  <c:v>0.122666666666667</c:v>
                </c:pt>
                <c:pt idx="1">
                  <c:v>0.545666666666667</c:v>
                </c:pt>
                <c:pt idx="2">
                  <c:v>0.500666666666667</c:v>
                </c:pt>
                <c:pt idx="3">
                  <c:v>0.489</c:v>
                </c:pt>
                <c:pt idx="4">
                  <c:v>0.468666666666667</c:v>
                </c:pt>
                <c:pt idx="5">
                  <c:v>0.459666666666667</c:v>
                </c:pt>
                <c:pt idx="6">
                  <c:v>0.457333333333333</c:v>
                </c:pt>
                <c:pt idx="7">
                  <c:v>0.453</c:v>
                </c:pt>
                <c:pt idx="8">
                  <c:v>0.418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-2100584488"/>
        <c:axId val="-2036785848"/>
      </c:lineChart>
      <c:dateAx>
        <c:axId val="-210058448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-2036785848"/>
        <c:crosses val="autoZero"/>
        <c:auto val="0"/>
        <c:lblOffset val="100"/>
        <c:baseTimeUnit val="days"/>
        <c:majorUnit val="3.0"/>
        <c:majorTimeUnit val="days"/>
      </c:dateAx>
      <c:valAx>
        <c:axId val="-2036785848"/>
        <c:scaling>
          <c:orientation val="minMax"/>
          <c:max val="4.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-2100584488"/>
        <c:crosses val="autoZero"/>
        <c:crossBetween val="midCat"/>
      </c:valAx>
    </c:plotArea>
    <c:plotVisOnly val="1"/>
    <c:dispBlanksAs val="gap"/>
    <c:showDLblsOverMax val="0"/>
  </c:chart>
  <c:externalData r:id="rId2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0913959489116673"/>
          <c:y val="0.212457032791696"/>
          <c:w val="0.525170793272222"/>
          <c:h val="0.648239820271414"/>
        </c:manualLayout>
      </c:layout>
      <c:scatterChart>
        <c:scatterStyle val="lineMarker"/>
        <c:varyColors val="0"/>
        <c:ser>
          <c:idx val="5"/>
          <c:order val="0"/>
          <c:tx>
            <c:strRef>
              <c:f>'Glucose assay data'!$A$8</c:f>
              <c:strCache>
                <c:ptCount val="1"/>
                <c:pt idx="0">
                  <c:v>adh1.BUTR+5g</c:v>
                </c:pt>
              </c:strCache>
            </c:strRef>
          </c:tx>
          <c:spPr>
            <a:ln w="12700"/>
          </c:spPr>
          <c:marker>
            <c:symbol val="circle"/>
            <c:size val="3"/>
          </c:marker>
          <c:errBars>
            <c:errDir val="y"/>
            <c:errBarType val="both"/>
            <c:errValType val="cust"/>
            <c:noEndCap val="0"/>
            <c:plus>
              <c:numRef>
                <c:f>'Glucose assay data'!$B$16:$H$16</c:f>
                <c:numCache>
                  <c:formatCode>General</c:formatCode>
                  <c:ptCount val="7"/>
                  <c:pt idx="0">
                    <c:v>0.376017970687374</c:v>
                  </c:pt>
                  <c:pt idx="1">
                    <c:v>0.696488365218368</c:v>
                  </c:pt>
                  <c:pt idx="2">
                    <c:v>1.086942866226244</c:v>
                  </c:pt>
                  <c:pt idx="3">
                    <c:v>0.172597789701976</c:v>
                  </c:pt>
                  <c:pt idx="4">
                    <c:v>0.0532804204307428</c:v>
                  </c:pt>
                  <c:pt idx="5">
                    <c:v>0.16829471367068</c:v>
                  </c:pt>
                  <c:pt idx="6">
                    <c:v>0.0664844226326128</c:v>
                  </c:pt>
                </c:numCache>
              </c:numRef>
            </c:plus>
            <c:minus>
              <c:numRef>
                <c:f>'Glucose assay data'!$B$16:$H$16</c:f>
                <c:numCache>
                  <c:formatCode>General</c:formatCode>
                  <c:ptCount val="7"/>
                  <c:pt idx="0">
                    <c:v>0.376017970687374</c:v>
                  </c:pt>
                  <c:pt idx="1">
                    <c:v>0.696488365218368</c:v>
                  </c:pt>
                  <c:pt idx="2">
                    <c:v>1.086942866226244</c:v>
                  </c:pt>
                  <c:pt idx="3">
                    <c:v>0.172597789701976</c:v>
                  </c:pt>
                  <c:pt idx="4">
                    <c:v>0.0532804204307428</c:v>
                  </c:pt>
                  <c:pt idx="5">
                    <c:v>0.16829471367068</c:v>
                  </c:pt>
                  <c:pt idx="6">
                    <c:v>0.0664844226326128</c:v>
                  </c:pt>
                </c:numCache>
              </c:numRef>
            </c:minus>
          </c:errBars>
          <c:xVal>
            <c:numRef>
              <c:f>'Glucose assay data'!$B$2:$H$2</c:f>
              <c:numCache>
                <c:formatCode>General</c:formatCode>
                <c:ptCount val="7"/>
                <c:pt idx="0">
                  <c:v>0.0</c:v>
                </c:pt>
                <c:pt idx="1">
                  <c:v>2.0</c:v>
                </c:pt>
                <c:pt idx="2">
                  <c:v>4.0</c:v>
                </c:pt>
                <c:pt idx="3">
                  <c:v>7.0</c:v>
                </c:pt>
                <c:pt idx="4">
                  <c:v>9.0</c:v>
                </c:pt>
                <c:pt idx="5">
                  <c:v>11.0</c:v>
                </c:pt>
                <c:pt idx="6">
                  <c:v>21.0</c:v>
                </c:pt>
              </c:numCache>
            </c:numRef>
          </c:xVal>
          <c:yVal>
            <c:numRef>
              <c:f>'Glucose assay data'!$B$8:$H$8</c:f>
              <c:numCache>
                <c:formatCode>General</c:formatCode>
                <c:ptCount val="7"/>
                <c:pt idx="0">
                  <c:v>100.0</c:v>
                </c:pt>
                <c:pt idx="1">
                  <c:v>42.55260203668659</c:v>
                </c:pt>
                <c:pt idx="2">
                  <c:v>5.687576619319196</c:v>
                </c:pt>
                <c:pt idx="3">
                  <c:v>0.884403275360107</c:v>
                </c:pt>
                <c:pt idx="4">
                  <c:v>0.58108462886387</c:v>
                </c:pt>
                <c:pt idx="5">
                  <c:v>0.987690365296051</c:v>
                </c:pt>
                <c:pt idx="6">
                  <c:v>0.365286694708878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1969469576"/>
        <c:axId val="-1969466872"/>
      </c:scatterChart>
      <c:valAx>
        <c:axId val="-1969469576"/>
        <c:scaling>
          <c:orientation val="minMax"/>
          <c:max val="21.0"/>
          <c:min val="0.0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-1969466872"/>
        <c:crosses val="autoZero"/>
        <c:crossBetween val="midCat"/>
        <c:majorUnit val="3.0"/>
        <c:minorUnit val="0.6"/>
      </c:valAx>
      <c:valAx>
        <c:axId val="-1969466872"/>
        <c:scaling>
          <c:orientation val="minMax"/>
          <c:max val="100.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-1969469576"/>
        <c:crosses val="autoZero"/>
        <c:crossBetween val="midCat"/>
      </c:valAx>
    </c:plotArea>
    <c:plotVisOnly val="1"/>
    <c:dispBlanksAs val="gap"/>
    <c:showDLblsOverMax val="0"/>
  </c:chart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24236017834861"/>
          <c:y val="0.14750167523216"/>
          <c:w val="0.560208369610218"/>
          <c:h val="0.652451159433211"/>
        </c:manualLayout>
      </c:layout>
      <c:lineChart>
        <c:grouping val="standard"/>
        <c:varyColors val="0"/>
        <c:ser>
          <c:idx val="2"/>
          <c:order val="0"/>
          <c:tx>
            <c:strRef>
              <c:f>'Reems - growth rate data'!$B$9</c:f>
              <c:strCache>
                <c:ptCount val="1"/>
                <c:pt idx="0">
                  <c:v>adh1.ymk23</c:v>
                </c:pt>
              </c:strCache>
            </c:strRef>
          </c:tx>
          <c:spPr>
            <a:ln w="12700">
              <a:solidFill>
                <a:srgbClr val="46AAC5"/>
              </a:solidFill>
            </a:ln>
          </c:spPr>
          <c:marker>
            <c:symbol val="star"/>
            <c:size val="3"/>
            <c:spPr>
              <a:noFill/>
              <a:ln>
                <a:solidFill>
                  <a:srgbClr val="46AAC5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Reems - growth rate data'!$C$21:$K$21</c:f>
                <c:numCache>
                  <c:formatCode>General</c:formatCode>
                  <c:ptCount val="9"/>
                  <c:pt idx="0">
                    <c:v>0.00680685928555405</c:v>
                  </c:pt>
                  <c:pt idx="1">
                    <c:v>0.0395516539898564</c:v>
                  </c:pt>
                  <c:pt idx="2">
                    <c:v>0.0148436293854749</c:v>
                  </c:pt>
                  <c:pt idx="3">
                    <c:v>0.0123423390543824</c:v>
                  </c:pt>
                  <c:pt idx="4">
                    <c:v>0.0109696551146029</c:v>
                  </c:pt>
                  <c:pt idx="5">
                    <c:v>0.0122202018532156</c:v>
                  </c:pt>
                  <c:pt idx="6">
                    <c:v>0.0155349069303081</c:v>
                  </c:pt>
                  <c:pt idx="7">
                    <c:v>0.0115902257671425</c:v>
                  </c:pt>
                  <c:pt idx="8">
                    <c:v>0.0170977581376427</c:v>
                  </c:pt>
                </c:numCache>
              </c:numRef>
            </c:plus>
            <c:minus>
              <c:numRef>
                <c:f>'Reems - growth rate data'!$C$21:$K$21</c:f>
                <c:numCache>
                  <c:formatCode>General</c:formatCode>
                  <c:ptCount val="9"/>
                  <c:pt idx="0">
                    <c:v>0.00680685928555405</c:v>
                  </c:pt>
                  <c:pt idx="1">
                    <c:v>0.0395516539898564</c:v>
                  </c:pt>
                  <c:pt idx="2">
                    <c:v>0.0148436293854749</c:v>
                  </c:pt>
                  <c:pt idx="3">
                    <c:v>0.0123423390543824</c:v>
                  </c:pt>
                  <c:pt idx="4">
                    <c:v>0.0109696551146029</c:v>
                  </c:pt>
                  <c:pt idx="5">
                    <c:v>0.0122202018532156</c:v>
                  </c:pt>
                  <c:pt idx="6">
                    <c:v>0.0155349069303081</c:v>
                  </c:pt>
                  <c:pt idx="7">
                    <c:v>0.0115902257671425</c:v>
                  </c:pt>
                  <c:pt idx="8">
                    <c:v>0.0170977581376427</c:v>
                  </c:pt>
                </c:numCache>
              </c:numRef>
            </c:minus>
          </c:errBars>
          <c:cat>
            <c:numRef>
              <c:f>'Reems - growth rate data'!$C$6:$K$6</c:f>
              <c:numCache>
                <c:formatCode>General</c:formatCode>
                <c:ptCount val="9"/>
                <c:pt idx="0">
                  <c:v>0.0</c:v>
                </c:pt>
                <c:pt idx="1">
                  <c:v>4.0</c:v>
                </c:pt>
                <c:pt idx="2">
                  <c:v>7.0</c:v>
                </c:pt>
                <c:pt idx="3">
                  <c:v>9.0</c:v>
                </c:pt>
                <c:pt idx="4">
                  <c:v>11.0</c:v>
                </c:pt>
                <c:pt idx="5">
                  <c:v>13.0</c:v>
                </c:pt>
                <c:pt idx="6">
                  <c:v>15.0</c:v>
                </c:pt>
                <c:pt idx="7">
                  <c:v>17.0</c:v>
                </c:pt>
                <c:pt idx="8">
                  <c:v>21.0</c:v>
                </c:pt>
              </c:numCache>
            </c:numRef>
          </c:cat>
          <c:val>
            <c:numRef>
              <c:f>'Reems - growth rate data'!$C$9:$K$9</c:f>
              <c:numCache>
                <c:formatCode>General</c:formatCode>
                <c:ptCount val="9"/>
                <c:pt idx="0">
                  <c:v>0.131333333333333</c:v>
                </c:pt>
                <c:pt idx="1">
                  <c:v>0.193333333333333</c:v>
                </c:pt>
                <c:pt idx="2">
                  <c:v>0.160666666666667</c:v>
                </c:pt>
                <c:pt idx="3">
                  <c:v>0.160333333333333</c:v>
                </c:pt>
                <c:pt idx="4">
                  <c:v>0.147666666666667</c:v>
                </c:pt>
                <c:pt idx="5">
                  <c:v>0.136666666666667</c:v>
                </c:pt>
                <c:pt idx="6">
                  <c:v>0.142666666666667</c:v>
                </c:pt>
                <c:pt idx="7">
                  <c:v>0.139333333333333</c:v>
                </c:pt>
                <c:pt idx="8">
                  <c:v>0.122333333333333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-2087345432"/>
        <c:axId val="-2087608504"/>
      </c:lineChart>
      <c:dateAx>
        <c:axId val="-208734543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-2087608504"/>
        <c:crosses val="autoZero"/>
        <c:auto val="0"/>
        <c:lblOffset val="100"/>
        <c:baseTimeUnit val="days"/>
        <c:majorUnit val="3.0"/>
        <c:majorTimeUnit val="days"/>
      </c:dateAx>
      <c:valAx>
        <c:axId val="-2087608504"/>
        <c:scaling>
          <c:orientation val="minMax"/>
          <c:max val="4.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-2087345432"/>
        <c:crosses val="autoZero"/>
        <c:crossBetween val="midCat"/>
      </c:valAx>
    </c:plotArea>
    <c:plotVisOnly val="1"/>
    <c:dispBlanksAs val="gap"/>
    <c:showDLblsOverMax val="0"/>
  </c:chart>
  <c:externalData r:id="rId2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24236017834861"/>
          <c:y val="0.14750167523216"/>
          <c:w val="0.560208369610218"/>
          <c:h val="0.652451159433211"/>
        </c:manualLayout>
      </c:layout>
      <c:lineChart>
        <c:grouping val="standard"/>
        <c:varyColors val="0"/>
        <c:ser>
          <c:idx val="3"/>
          <c:order val="0"/>
          <c:tx>
            <c:strRef>
              <c:f>'Reems - growth rate data'!$B$10</c:f>
              <c:strCache>
                <c:ptCount val="1"/>
                <c:pt idx="0">
                  <c:v>adh1.BUTR+5g</c:v>
                </c:pt>
              </c:strCache>
            </c:strRef>
          </c:tx>
          <c:spPr>
            <a:ln w="12700"/>
          </c:spPr>
          <c:marker>
            <c:symbol val="x"/>
            <c:size val="3"/>
          </c:marker>
          <c:errBars>
            <c:errDir val="y"/>
            <c:errBarType val="both"/>
            <c:errValType val="cust"/>
            <c:noEndCap val="0"/>
            <c:plus>
              <c:numRef>
                <c:f>'Reems - growth rate data'!$C$22:$K$22</c:f>
                <c:numCache>
                  <c:formatCode>General</c:formatCode>
                  <c:ptCount val="9"/>
                  <c:pt idx="0">
                    <c:v>0.0127671453348037</c:v>
                  </c:pt>
                  <c:pt idx="1">
                    <c:v>0.061133733186624</c:v>
                  </c:pt>
                  <c:pt idx="2">
                    <c:v>0.0978229693545102</c:v>
                  </c:pt>
                  <c:pt idx="3">
                    <c:v>0.0927739187487513</c:v>
                  </c:pt>
                  <c:pt idx="4">
                    <c:v>0.0892767233568382</c:v>
                  </c:pt>
                  <c:pt idx="5">
                    <c:v>0.0902348786962855</c:v>
                  </c:pt>
                  <c:pt idx="6">
                    <c:v>0.0642105910267136</c:v>
                  </c:pt>
                  <c:pt idx="7">
                    <c:v>0.0570116947067296</c:v>
                  </c:pt>
                  <c:pt idx="8">
                    <c:v>0.0355715241918776</c:v>
                  </c:pt>
                </c:numCache>
              </c:numRef>
            </c:plus>
            <c:minus>
              <c:numRef>
                <c:f>'Reems - growth rate data'!$C$22:$K$22</c:f>
                <c:numCache>
                  <c:formatCode>General</c:formatCode>
                  <c:ptCount val="9"/>
                  <c:pt idx="0">
                    <c:v>0.0127671453348037</c:v>
                  </c:pt>
                  <c:pt idx="1">
                    <c:v>0.061133733186624</c:v>
                  </c:pt>
                  <c:pt idx="2">
                    <c:v>0.0978229693545102</c:v>
                  </c:pt>
                  <c:pt idx="3">
                    <c:v>0.0927739187487513</c:v>
                  </c:pt>
                  <c:pt idx="4">
                    <c:v>0.0892767233568382</c:v>
                  </c:pt>
                  <c:pt idx="5">
                    <c:v>0.0902348786962855</c:v>
                  </c:pt>
                  <c:pt idx="6">
                    <c:v>0.0642105910267136</c:v>
                  </c:pt>
                  <c:pt idx="7">
                    <c:v>0.0570116947067296</c:v>
                  </c:pt>
                  <c:pt idx="8">
                    <c:v>0.0355715241918776</c:v>
                  </c:pt>
                </c:numCache>
              </c:numRef>
            </c:minus>
          </c:errBars>
          <c:cat>
            <c:numRef>
              <c:f>'Reems - growth rate data'!$C$6:$K$6</c:f>
              <c:numCache>
                <c:formatCode>General</c:formatCode>
                <c:ptCount val="9"/>
                <c:pt idx="0">
                  <c:v>0.0</c:v>
                </c:pt>
                <c:pt idx="1">
                  <c:v>4.0</c:v>
                </c:pt>
                <c:pt idx="2">
                  <c:v>7.0</c:v>
                </c:pt>
                <c:pt idx="3">
                  <c:v>9.0</c:v>
                </c:pt>
                <c:pt idx="4">
                  <c:v>11.0</c:v>
                </c:pt>
                <c:pt idx="5">
                  <c:v>13.0</c:v>
                </c:pt>
                <c:pt idx="6">
                  <c:v>15.0</c:v>
                </c:pt>
                <c:pt idx="7">
                  <c:v>17.0</c:v>
                </c:pt>
                <c:pt idx="8">
                  <c:v>21.0</c:v>
                </c:pt>
              </c:numCache>
            </c:numRef>
          </c:cat>
          <c:val>
            <c:numRef>
              <c:f>'Reems - growth rate data'!$C$10:$K$10</c:f>
              <c:numCache>
                <c:formatCode>General</c:formatCode>
                <c:ptCount val="9"/>
                <c:pt idx="0">
                  <c:v>0.12</c:v>
                </c:pt>
                <c:pt idx="1">
                  <c:v>0.695333333333333</c:v>
                </c:pt>
                <c:pt idx="2">
                  <c:v>0.648666666666667</c:v>
                </c:pt>
                <c:pt idx="3">
                  <c:v>0.638</c:v>
                </c:pt>
                <c:pt idx="4">
                  <c:v>0.607333333333333</c:v>
                </c:pt>
                <c:pt idx="5">
                  <c:v>0.565333333333333</c:v>
                </c:pt>
                <c:pt idx="6">
                  <c:v>0.51</c:v>
                </c:pt>
                <c:pt idx="7">
                  <c:v>0.484666666666667</c:v>
                </c:pt>
                <c:pt idx="8">
                  <c:v>0.440666666666667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126698520"/>
        <c:axId val="-2011379352"/>
      </c:lineChart>
      <c:dateAx>
        <c:axId val="212669852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-2011379352"/>
        <c:crosses val="autoZero"/>
        <c:auto val="0"/>
        <c:lblOffset val="100"/>
        <c:baseTimeUnit val="days"/>
        <c:majorUnit val="3.0"/>
        <c:majorTimeUnit val="days"/>
      </c:dateAx>
      <c:valAx>
        <c:axId val="-2011379352"/>
        <c:scaling>
          <c:orientation val="minMax"/>
          <c:max val="4.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2126698520"/>
        <c:crosses val="autoZero"/>
        <c:crossBetween val="midCat"/>
      </c:valAx>
    </c:plotArea>
    <c:plotVisOnly val="1"/>
    <c:dispBlanksAs val="gap"/>
    <c:showDLblsOverMax val="0"/>
  </c:chart>
  <c:externalData r:id="rId2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0913959489116673"/>
          <c:y val="0.212457032791696"/>
          <c:w val="0.525170793272222"/>
          <c:h val="0.648239820271414"/>
        </c:manualLayout>
      </c:layout>
      <c:scatterChart>
        <c:scatterStyle val="lineMarker"/>
        <c:varyColors val="0"/>
        <c:ser>
          <c:idx val="3"/>
          <c:order val="0"/>
          <c:tx>
            <c:strRef>
              <c:f>'Glucose assay data'!$A$6</c:f>
              <c:strCache>
                <c:ptCount val="1"/>
                <c:pt idx="0">
                  <c:v>adh1.ALD6.ACS2.BUTS+5g</c:v>
                </c:pt>
              </c:strCache>
            </c:strRef>
          </c:tx>
          <c:spPr>
            <a:ln w="12700"/>
          </c:spPr>
          <c:marker>
            <c:symbol val="x"/>
            <c:size val="3"/>
          </c:marker>
          <c:errBars>
            <c:errDir val="y"/>
            <c:errBarType val="both"/>
            <c:errValType val="cust"/>
            <c:noEndCap val="0"/>
            <c:plus>
              <c:numRef>
                <c:f>'Glucose assay data'!$B$14:$H$14</c:f>
                <c:numCache>
                  <c:formatCode>General</c:formatCode>
                  <c:ptCount val="7"/>
                  <c:pt idx="0">
                    <c:v>0.395896896977457</c:v>
                  </c:pt>
                  <c:pt idx="1">
                    <c:v>5.22242847171884</c:v>
                  </c:pt>
                  <c:pt idx="2">
                    <c:v>0.118883838506291</c:v>
                  </c:pt>
                  <c:pt idx="3">
                    <c:v>0.445616490303592</c:v>
                  </c:pt>
                  <c:pt idx="4">
                    <c:v>0.0621866520753359</c:v>
                  </c:pt>
                  <c:pt idx="5">
                    <c:v>0.0177158385711756</c:v>
                  </c:pt>
                  <c:pt idx="6">
                    <c:v>0.00724640243304099</c:v>
                  </c:pt>
                </c:numCache>
              </c:numRef>
            </c:plus>
            <c:minus>
              <c:numRef>
                <c:f>'Glucose assay data'!$B$14:$H$14</c:f>
                <c:numCache>
                  <c:formatCode>General</c:formatCode>
                  <c:ptCount val="7"/>
                  <c:pt idx="0">
                    <c:v>0.395896896977457</c:v>
                  </c:pt>
                  <c:pt idx="1">
                    <c:v>5.22242847171884</c:v>
                  </c:pt>
                  <c:pt idx="2">
                    <c:v>0.118883838506291</c:v>
                  </c:pt>
                  <c:pt idx="3">
                    <c:v>0.445616490303592</c:v>
                  </c:pt>
                  <c:pt idx="4">
                    <c:v>0.0621866520753359</c:v>
                  </c:pt>
                  <c:pt idx="5">
                    <c:v>0.0177158385711756</c:v>
                  </c:pt>
                  <c:pt idx="6">
                    <c:v>0.00724640243304099</c:v>
                  </c:pt>
                </c:numCache>
              </c:numRef>
            </c:minus>
          </c:errBars>
          <c:xVal>
            <c:numRef>
              <c:f>'Glucose assay data'!$B$2:$H$2</c:f>
              <c:numCache>
                <c:formatCode>General</c:formatCode>
                <c:ptCount val="7"/>
                <c:pt idx="0">
                  <c:v>0.0</c:v>
                </c:pt>
                <c:pt idx="1">
                  <c:v>2.0</c:v>
                </c:pt>
                <c:pt idx="2">
                  <c:v>4.0</c:v>
                </c:pt>
                <c:pt idx="3">
                  <c:v>7.0</c:v>
                </c:pt>
                <c:pt idx="4">
                  <c:v>9.0</c:v>
                </c:pt>
                <c:pt idx="5">
                  <c:v>11.0</c:v>
                </c:pt>
                <c:pt idx="6">
                  <c:v>21.0</c:v>
                </c:pt>
              </c:numCache>
            </c:numRef>
          </c:xVal>
          <c:yVal>
            <c:numRef>
              <c:f>'Glucose assay data'!$B$6:$H$6</c:f>
              <c:numCache>
                <c:formatCode>General</c:formatCode>
                <c:ptCount val="7"/>
                <c:pt idx="0">
                  <c:v>100.0</c:v>
                </c:pt>
                <c:pt idx="1">
                  <c:v>37.97162420642184</c:v>
                </c:pt>
                <c:pt idx="2">
                  <c:v>1.838293103173988</c:v>
                </c:pt>
                <c:pt idx="3">
                  <c:v>1.083209269397146</c:v>
                </c:pt>
                <c:pt idx="4">
                  <c:v>0.474913848201001</c:v>
                </c:pt>
                <c:pt idx="5">
                  <c:v>0.390623708648581</c:v>
                </c:pt>
                <c:pt idx="6">
                  <c:v>0.0890554392152541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085373832"/>
        <c:axId val="-2085370808"/>
      </c:scatterChart>
      <c:valAx>
        <c:axId val="-2085373832"/>
        <c:scaling>
          <c:orientation val="minMax"/>
          <c:max val="21.0"/>
          <c:min val="0.0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-2085370808"/>
        <c:crosses val="autoZero"/>
        <c:crossBetween val="midCat"/>
        <c:majorUnit val="3.0"/>
        <c:minorUnit val="0.6"/>
      </c:valAx>
      <c:valAx>
        <c:axId val="-2085370808"/>
        <c:scaling>
          <c:orientation val="minMax"/>
          <c:max val="100.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-2085373832"/>
        <c:crosses val="autoZero"/>
        <c:crossBetween val="midCat"/>
      </c:valAx>
      <c:spPr>
        <a:noFill/>
        <a:ln w="25400">
          <a:noFill/>
        </a:ln>
      </c:spPr>
    </c:plotArea>
    <c:plotVisOnly val="1"/>
    <c:dispBlanksAs val="gap"/>
    <c:showDLblsOverMax val="0"/>
  </c:chart>
  <c:externalData r:id="rId2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0913959489116673"/>
          <c:y val="0.212457032791696"/>
          <c:w val="0.525170793272222"/>
          <c:h val="0.648239820271414"/>
        </c:manualLayout>
      </c:layout>
      <c:scatterChart>
        <c:scatterStyle val="lineMarker"/>
        <c:varyColors val="0"/>
        <c:ser>
          <c:idx val="4"/>
          <c:order val="0"/>
          <c:tx>
            <c:strRef>
              <c:f>'Glucose assay data'!$A$7</c:f>
              <c:strCache>
                <c:ptCount val="1"/>
                <c:pt idx="0">
                  <c:v>adh1.ymk23</c:v>
                </c:pt>
              </c:strCache>
            </c:strRef>
          </c:tx>
          <c:spPr>
            <a:ln w="12700"/>
          </c:spPr>
          <c:marker>
            <c:symbol val="star"/>
            <c:size val="3"/>
          </c:marker>
          <c:errBars>
            <c:errDir val="y"/>
            <c:errBarType val="both"/>
            <c:errValType val="cust"/>
            <c:noEndCap val="0"/>
            <c:plus>
              <c:numRef>
                <c:f>'Glucose assay data'!$B$15:$I$15</c:f>
                <c:numCache>
                  <c:formatCode>General</c:formatCode>
                  <c:ptCount val="8"/>
                  <c:pt idx="0">
                    <c:v>0.381420334121807</c:v>
                  </c:pt>
                  <c:pt idx="1">
                    <c:v>1.40601446466293</c:v>
                  </c:pt>
                  <c:pt idx="2">
                    <c:v>0.817225598155086</c:v>
                  </c:pt>
                  <c:pt idx="3">
                    <c:v>1.909110780602789</c:v>
                  </c:pt>
                  <c:pt idx="4">
                    <c:v>0.185606025130744</c:v>
                  </c:pt>
                  <c:pt idx="5">
                    <c:v>0.0588230544363313</c:v>
                  </c:pt>
                  <c:pt idx="6">
                    <c:v>0.0647961664123271</c:v>
                  </c:pt>
                </c:numCache>
              </c:numRef>
            </c:plus>
            <c:minus>
              <c:numRef>
                <c:f>'Glucose assay data'!$B$15:$H$15</c:f>
                <c:numCache>
                  <c:formatCode>General</c:formatCode>
                  <c:ptCount val="7"/>
                  <c:pt idx="0">
                    <c:v>0.381420334121807</c:v>
                  </c:pt>
                  <c:pt idx="1">
                    <c:v>1.40601446466293</c:v>
                  </c:pt>
                  <c:pt idx="2">
                    <c:v>0.817225598155086</c:v>
                  </c:pt>
                  <c:pt idx="3">
                    <c:v>1.909110780602789</c:v>
                  </c:pt>
                  <c:pt idx="4">
                    <c:v>0.185606025130744</c:v>
                  </c:pt>
                  <c:pt idx="5">
                    <c:v>0.0588230544363313</c:v>
                  </c:pt>
                  <c:pt idx="6">
                    <c:v>0.0647961664123271</c:v>
                  </c:pt>
                </c:numCache>
              </c:numRef>
            </c:minus>
          </c:errBars>
          <c:xVal>
            <c:numRef>
              <c:f>'Glucose assay data'!$B$2:$H$2</c:f>
              <c:numCache>
                <c:formatCode>General</c:formatCode>
                <c:ptCount val="7"/>
                <c:pt idx="0">
                  <c:v>0.0</c:v>
                </c:pt>
                <c:pt idx="1">
                  <c:v>2.0</c:v>
                </c:pt>
                <c:pt idx="2">
                  <c:v>4.0</c:v>
                </c:pt>
                <c:pt idx="3">
                  <c:v>7.0</c:v>
                </c:pt>
                <c:pt idx="4">
                  <c:v>9.0</c:v>
                </c:pt>
                <c:pt idx="5">
                  <c:v>11.0</c:v>
                </c:pt>
                <c:pt idx="6">
                  <c:v>21.0</c:v>
                </c:pt>
              </c:numCache>
            </c:numRef>
          </c:xVal>
          <c:yVal>
            <c:numRef>
              <c:f>'Glucose assay data'!$B$7:$H$7</c:f>
              <c:numCache>
                <c:formatCode>General</c:formatCode>
                <c:ptCount val="7"/>
                <c:pt idx="0">
                  <c:v>100.0</c:v>
                </c:pt>
                <c:pt idx="1">
                  <c:v>67.72991189261101</c:v>
                </c:pt>
                <c:pt idx="2">
                  <c:v>25.25724067059551</c:v>
                </c:pt>
                <c:pt idx="3">
                  <c:v>15.98334581587725</c:v>
                </c:pt>
                <c:pt idx="4">
                  <c:v>9.7025864741259</c:v>
                </c:pt>
                <c:pt idx="5">
                  <c:v>9.516173687711037</c:v>
                </c:pt>
                <c:pt idx="6">
                  <c:v>11.49811780336581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086936536"/>
        <c:axId val="-2087649432"/>
      </c:scatterChart>
      <c:valAx>
        <c:axId val="-2086936536"/>
        <c:scaling>
          <c:orientation val="minMax"/>
          <c:max val="21.0"/>
          <c:min val="0.0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-2087649432"/>
        <c:crosses val="autoZero"/>
        <c:crossBetween val="midCat"/>
        <c:majorUnit val="3.0"/>
        <c:minorUnit val="0.6"/>
      </c:valAx>
      <c:valAx>
        <c:axId val="-2087649432"/>
        <c:scaling>
          <c:orientation val="minMax"/>
          <c:max val="100.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-2086936536"/>
        <c:crosses val="autoZero"/>
        <c:crossBetween val="midCat"/>
      </c:valAx>
    </c:plotArea>
    <c:plotVisOnly val="1"/>
    <c:dispBlanksAs val="gap"/>
    <c:showDLblsOverMax val="0"/>
  </c:chart>
  <c:externalData r:id="rId2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09139602588342"/>
          <c:y val="0.182243368966459"/>
          <c:w val="0.525170793272222"/>
          <c:h val="0.658949997807365"/>
        </c:manualLayout>
      </c:layout>
      <c:scatterChart>
        <c:scatterStyle val="lineMarker"/>
        <c:varyColors val="0"/>
        <c:ser>
          <c:idx val="0"/>
          <c:order val="0"/>
          <c:tx>
            <c:strRef>
              <c:f>'Glucose assay data'!$A$3</c:f>
              <c:strCache>
                <c:ptCount val="1"/>
                <c:pt idx="0">
                  <c:v>BUTR+5g</c:v>
                </c:pt>
              </c:strCache>
            </c:strRef>
          </c:tx>
          <c:spPr>
            <a:ln w="12700"/>
          </c:spPr>
          <c:marker>
            <c:symbol val="diamond"/>
            <c:size val="3"/>
          </c:marker>
          <c:errBars>
            <c:errDir val="y"/>
            <c:errBarType val="both"/>
            <c:errValType val="cust"/>
            <c:noEndCap val="0"/>
            <c:plus>
              <c:numRef>
                <c:f>'Glucose assay data'!$B$11:$H$11</c:f>
                <c:numCache>
                  <c:formatCode>General</c:formatCode>
                  <c:ptCount val="7"/>
                  <c:pt idx="0">
                    <c:v>0.042035478260274</c:v>
                  </c:pt>
                  <c:pt idx="1">
                    <c:v>0.092185772401705</c:v>
                  </c:pt>
                  <c:pt idx="2">
                    <c:v>0.0271308258146895</c:v>
                  </c:pt>
                  <c:pt idx="3">
                    <c:v>0.00199143611776962</c:v>
                  </c:pt>
                  <c:pt idx="4">
                    <c:v>0.159473549763883</c:v>
                  </c:pt>
                  <c:pt idx="5">
                    <c:v>0.0884531005998728</c:v>
                  </c:pt>
                  <c:pt idx="6">
                    <c:v>0.000728075840672507</c:v>
                  </c:pt>
                </c:numCache>
              </c:numRef>
            </c:plus>
            <c:minus>
              <c:numRef>
                <c:f>'Glucose assay data'!$B$11:$H$11</c:f>
                <c:numCache>
                  <c:formatCode>General</c:formatCode>
                  <c:ptCount val="7"/>
                  <c:pt idx="0">
                    <c:v>0.042035478260274</c:v>
                  </c:pt>
                  <c:pt idx="1">
                    <c:v>0.092185772401705</c:v>
                  </c:pt>
                  <c:pt idx="2">
                    <c:v>0.0271308258146895</c:v>
                  </c:pt>
                  <c:pt idx="3">
                    <c:v>0.00199143611776962</c:v>
                  </c:pt>
                  <c:pt idx="4">
                    <c:v>0.159473549763883</c:v>
                  </c:pt>
                  <c:pt idx="5">
                    <c:v>0.0884531005998728</c:v>
                  </c:pt>
                  <c:pt idx="6">
                    <c:v>0.000728075840672507</c:v>
                  </c:pt>
                </c:numCache>
              </c:numRef>
            </c:minus>
          </c:errBars>
          <c:xVal>
            <c:numRef>
              <c:f>'Glucose assay data'!$B$2:$H$2</c:f>
              <c:numCache>
                <c:formatCode>General</c:formatCode>
                <c:ptCount val="7"/>
                <c:pt idx="0">
                  <c:v>0.0</c:v>
                </c:pt>
                <c:pt idx="1">
                  <c:v>2.0</c:v>
                </c:pt>
                <c:pt idx="2">
                  <c:v>4.0</c:v>
                </c:pt>
                <c:pt idx="3">
                  <c:v>7.0</c:v>
                </c:pt>
                <c:pt idx="4">
                  <c:v>9.0</c:v>
                </c:pt>
                <c:pt idx="5">
                  <c:v>11.0</c:v>
                </c:pt>
                <c:pt idx="6">
                  <c:v>21.0</c:v>
                </c:pt>
              </c:numCache>
            </c:numRef>
          </c:xVal>
          <c:yVal>
            <c:numRef>
              <c:f>'Glucose assay data'!$B$3:$H$3</c:f>
              <c:numCache>
                <c:formatCode>General</c:formatCode>
                <c:ptCount val="7"/>
                <c:pt idx="0">
                  <c:v>100.0</c:v>
                </c:pt>
                <c:pt idx="1">
                  <c:v>1.469560546094797</c:v>
                </c:pt>
                <c:pt idx="2">
                  <c:v>0.0968392479423881</c:v>
                </c:pt>
                <c:pt idx="3">
                  <c:v>0.0674879707309839</c:v>
                </c:pt>
                <c:pt idx="4">
                  <c:v>0.811509763539007</c:v>
                </c:pt>
                <c:pt idx="5">
                  <c:v>0.386426775904085</c:v>
                </c:pt>
                <c:pt idx="6">
                  <c:v>0.0708082832331329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Glucose assay data'!$A$4</c:f>
              <c:strCache>
                <c:ptCount val="1"/>
                <c:pt idx="0">
                  <c:v>BUT S+ 5g</c:v>
                </c:pt>
              </c:strCache>
            </c:strRef>
          </c:tx>
          <c:spPr>
            <a:ln w="12700"/>
          </c:spPr>
          <c:marker>
            <c:symbol val="square"/>
            <c:size val="3"/>
          </c:marker>
          <c:errBars>
            <c:errDir val="y"/>
            <c:errBarType val="both"/>
            <c:errValType val="cust"/>
            <c:noEndCap val="0"/>
            <c:plus>
              <c:numRef>
                <c:f>'Glucose assay data'!$B$12:$H$12</c:f>
                <c:numCache>
                  <c:formatCode>General</c:formatCode>
                  <c:ptCount val="7"/>
                  <c:pt idx="0">
                    <c:v>0.0147308424670602</c:v>
                  </c:pt>
                  <c:pt idx="1">
                    <c:v>0.149192603332303</c:v>
                  </c:pt>
                  <c:pt idx="2">
                    <c:v>0.00132093153895879</c:v>
                  </c:pt>
                  <c:pt idx="3">
                    <c:v>0.000821894236676078</c:v>
                  </c:pt>
                  <c:pt idx="4">
                    <c:v>0.0302838268413493</c:v>
                  </c:pt>
                  <c:pt idx="5">
                    <c:v>0.0423464539284855</c:v>
                  </c:pt>
                  <c:pt idx="6">
                    <c:v>0.0020136428165477</c:v>
                  </c:pt>
                </c:numCache>
              </c:numRef>
            </c:plus>
            <c:minus>
              <c:numRef>
                <c:f>'Glucose assay data'!$B$12:$H$12</c:f>
                <c:numCache>
                  <c:formatCode>General</c:formatCode>
                  <c:ptCount val="7"/>
                  <c:pt idx="0">
                    <c:v>0.0147308424670602</c:v>
                  </c:pt>
                  <c:pt idx="1">
                    <c:v>0.149192603332303</c:v>
                  </c:pt>
                  <c:pt idx="2">
                    <c:v>0.00132093153895879</c:v>
                  </c:pt>
                  <c:pt idx="3">
                    <c:v>0.000821894236676078</c:v>
                  </c:pt>
                  <c:pt idx="4">
                    <c:v>0.0302838268413493</c:v>
                  </c:pt>
                  <c:pt idx="5">
                    <c:v>0.0423464539284855</c:v>
                  </c:pt>
                  <c:pt idx="6">
                    <c:v>0.0020136428165477</c:v>
                  </c:pt>
                </c:numCache>
              </c:numRef>
            </c:minus>
          </c:errBars>
          <c:xVal>
            <c:numRef>
              <c:f>'Glucose assay data'!$B$2:$H$2</c:f>
              <c:numCache>
                <c:formatCode>General</c:formatCode>
                <c:ptCount val="7"/>
                <c:pt idx="0">
                  <c:v>0.0</c:v>
                </c:pt>
                <c:pt idx="1">
                  <c:v>2.0</c:v>
                </c:pt>
                <c:pt idx="2">
                  <c:v>4.0</c:v>
                </c:pt>
                <c:pt idx="3">
                  <c:v>7.0</c:v>
                </c:pt>
                <c:pt idx="4">
                  <c:v>9.0</c:v>
                </c:pt>
                <c:pt idx="5">
                  <c:v>11.0</c:v>
                </c:pt>
                <c:pt idx="6">
                  <c:v>21.0</c:v>
                </c:pt>
              </c:numCache>
            </c:numRef>
          </c:xVal>
          <c:yVal>
            <c:numRef>
              <c:f>'Glucose assay data'!$B$4:$H$4</c:f>
              <c:numCache>
                <c:formatCode>General</c:formatCode>
                <c:ptCount val="7"/>
                <c:pt idx="0">
                  <c:v>100.0</c:v>
                </c:pt>
                <c:pt idx="1">
                  <c:v>2.025618031129663</c:v>
                </c:pt>
                <c:pt idx="2">
                  <c:v>0.0558161281122904</c:v>
                </c:pt>
                <c:pt idx="3">
                  <c:v>0.0625140634857652</c:v>
                </c:pt>
                <c:pt idx="4">
                  <c:v>0.453700334495062</c:v>
                </c:pt>
                <c:pt idx="5">
                  <c:v>0.402758898828451</c:v>
                </c:pt>
                <c:pt idx="6">
                  <c:v>0.0706201901312811</c:v>
                </c:pt>
              </c:numCache>
            </c:numRef>
          </c:yVal>
          <c:smooth val="0"/>
        </c:ser>
        <c:ser>
          <c:idx val="2"/>
          <c:order val="2"/>
          <c:tx>
            <c:strRef>
              <c:f>'Glucose assay data'!$A$5</c:f>
              <c:strCache>
                <c:ptCount val="1"/>
                <c:pt idx="0">
                  <c:v>adh1.ALD6.ACS2.BUTR+5g</c:v>
                </c:pt>
              </c:strCache>
            </c:strRef>
          </c:tx>
          <c:spPr>
            <a:ln w="12700"/>
          </c:spPr>
          <c:marker>
            <c:symbol val="triangle"/>
            <c:size val="3"/>
          </c:marker>
          <c:errBars>
            <c:errDir val="y"/>
            <c:errBarType val="both"/>
            <c:errValType val="cust"/>
            <c:noEndCap val="0"/>
            <c:plus>
              <c:numRef>
                <c:f>'Glucose assay data'!$B$13:$H$13</c:f>
                <c:numCache>
                  <c:formatCode>General</c:formatCode>
                  <c:ptCount val="7"/>
                  <c:pt idx="0">
                    <c:v>0.562341246114409</c:v>
                  </c:pt>
                  <c:pt idx="1">
                    <c:v>2.44119237600793</c:v>
                  </c:pt>
                  <c:pt idx="2">
                    <c:v>1.267297930219603</c:v>
                  </c:pt>
                  <c:pt idx="3">
                    <c:v>1.012660958329656</c:v>
                  </c:pt>
                  <c:pt idx="4">
                    <c:v>0.910534060176255</c:v>
                  </c:pt>
                  <c:pt idx="5">
                    <c:v>0.830271263992583</c:v>
                  </c:pt>
                  <c:pt idx="6">
                    <c:v>0.919344502296786</c:v>
                  </c:pt>
                </c:numCache>
              </c:numRef>
            </c:plus>
            <c:minus>
              <c:numRef>
                <c:f>'Glucose assay data'!$B$13:$H$13</c:f>
                <c:numCache>
                  <c:formatCode>General</c:formatCode>
                  <c:ptCount val="7"/>
                  <c:pt idx="0">
                    <c:v>0.562341246114409</c:v>
                  </c:pt>
                  <c:pt idx="1">
                    <c:v>2.44119237600793</c:v>
                  </c:pt>
                  <c:pt idx="2">
                    <c:v>1.267297930219603</c:v>
                  </c:pt>
                  <c:pt idx="3">
                    <c:v>1.012660958329656</c:v>
                  </c:pt>
                  <c:pt idx="4">
                    <c:v>0.910534060176255</c:v>
                  </c:pt>
                  <c:pt idx="5">
                    <c:v>0.830271263992583</c:v>
                  </c:pt>
                  <c:pt idx="6">
                    <c:v>0.919344502296786</c:v>
                  </c:pt>
                </c:numCache>
              </c:numRef>
            </c:minus>
          </c:errBars>
          <c:xVal>
            <c:numRef>
              <c:f>'Glucose assay data'!$B$2:$H$2</c:f>
              <c:numCache>
                <c:formatCode>General</c:formatCode>
                <c:ptCount val="7"/>
                <c:pt idx="0">
                  <c:v>0.0</c:v>
                </c:pt>
                <c:pt idx="1">
                  <c:v>2.0</c:v>
                </c:pt>
                <c:pt idx="2">
                  <c:v>4.0</c:v>
                </c:pt>
                <c:pt idx="3">
                  <c:v>7.0</c:v>
                </c:pt>
                <c:pt idx="4">
                  <c:v>9.0</c:v>
                </c:pt>
                <c:pt idx="5">
                  <c:v>11.0</c:v>
                </c:pt>
                <c:pt idx="6">
                  <c:v>21.0</c:v>
                </c:pt>
              </c:numCache>
            </c:numRef>
          </c:xVal>
          <c:yVal>
            <c:numRef>
              <c:f>'Glucose assay data'!$B$5:$H$5</c:f>
              <c:numCache>
                <c:formatCode>General</c:formatCode>
                <c:ptCount val="7"/>
                <c:pt idx="0">
                  <c:v>100.0</c:v>
                </c:pt>
                <c:pt idx="1">
                  <c:v>61.38784655952003</c:v>
                </c:pt>
                <c:pt idx="2">
                  <c:v>8.364207327588326</c:v>
                </c:pt>
                <c:pt idx="3">
                  <c:v>2.963204136271967</c:v>
                </c:pt>
                <c:pt idx="4">
                  <c:v>2.263790632342665</c:v>
                </c:pt>
                <c:pt idx="5">
                  <c:v>2.101268869845334</c:v>
                </c:pt>
                <c:pt idx="6">
                  <c:v>1.940621843080031</c:v>
                </c:pt>
              </c:numCache>
            </c:numRef>
          </c:yVal>
          <c:smooth val="0"/>
        </c:ser>
        <c:ser>
          <c:idx val="3"/>
          <c:order val="3"/>
          <c:tx>
            <c:strRef>
              <c:f>'Glucose assay data'!$A$6</c:f>
              <c:strCache>
                <c:ptCount val="1"/>
                <c:pt idx="0">
                  <c:v>adh1.ALD6.ACS2.BUTS+5g</c:v>
                </c:pt>
              </c:strCache>
            </c:strRef>
          </c:tx>
          <c:spPr>
            <a:ln w="12700"/>
          </c:spPr>
          <c:marker>
            <c:symbol val="x"/>
            <c:size val="3"/>
          </c:marker>
          <c:errBars>
            <c:errDir val="y"/>
            <c:errBarType val="both"/>
            <c:errValType val="cust"/>
            <c:noEndCap val="0"/>
            <c:plus>
              <c:numRef>
                <c:f>'Glucose assay data'!$B$14:$H$14</c:f>
                <c:numCache>
                  <c:formatCode>General</c:formatCode>
                  <c:ptCount val="7"/>
                  <c:pt idx="0">
                    <c:v>0.395896896977457</c:v>
                  </c:pt>
                  <c:pt idx="1">
                    <c:v>5.22242847171884</c:v>
                  </c:pt>
                  <c:pt idx="2">
                    <c:v>0.118883838506291</c:v>
                  </c:pt>
                  <c:pt idx="3">
                    <c:v>0.445616490303592</c:v>
                  </c:pt>
                  <c:pt idx="4">
                    <c:v>0.0621866520753359</c:v>
                  </c:pt>
                  <c:pt idx="5">
                    <c:v>0.0177158385711756</c:v>
                  </c:pt>
                  <c:pt idx="6">
                    <c:v>0.00724640243304099</c:v>
                  </c:pt>
                </c:numCache>
              </c:numRef>
            </c:plus>
            <c:minus>
              <c:numRef>
                <c:f>'Glucose assay data'!$B$14:$H$14</c:f>
                <c:numCache>
                  <c:formatCode>General</c:formatCode>
                  <c:ptCount val="7"/>
                  <c:pt idx="0">
                    <c:v>0.395896896977457</c:v>
                  </c:pt>
                  <c:pt idx="1">
                    <c:v>5.22242847171884</c:v>
                  </c:pt>
                  <c:pt idx="2">
                    <c:v>0.118883838506291</c:v>
                  </c:pt>
                  <c:pt idx="3">
                    <c:v>0.445616490303592</c:v>
                  </c:pt>
                  <c:pt idx="4">
                    <c:v>0.0621866520753359</c:v>
                  </c:pt>
                  <c:pt idx="5">
                    <c:v>0.0177158385711756</c:v>
                  </c:pt>
                  <c:pt idx="6">
                    <c:v>0.00724640243304099</c:v>
                  </c:pt>
                </c:numCache>
              </c:numRef>
            </c:minus>
          </c:errBars>
          <c:xVal>
            <c:numRef>
              <c:f>'Glucose assay data'!$B$2:$H$2</c:f>
              <c:numCache>
                <c:formatCode>General</c:formatCode>
                <c:ptCount val="7"/>
                <c:pt idx="0">
                  <c:v>0.0</c:v>
                </c:pt>
                <c:pt idx="1">
                  <c:v>2.0</c:v>
                </c:pt>
                <c:pt idx="2">
                  <c:v>4.0</c:v>
                </c:pt>
                <c:pt idx="3">
                  <c:v>7.0</c:v>
                </c:pt>
                <c:pt idx="4">
                  <c:v>9.0</c:v>
                </c:pt>
                <c:pt idx="5">
                  <c:v>11.0</c:v>
                </c:pt>
                <c:pt idx="6">
                  <c:v>21.0</c:v>
                </c:pt>
              </c:numCache>
            </c:numRef>
          </c:xVal>
          <c:yVal>
            <c:numRef>
              <c:f>'Glucose assay data'!$B$6:$H$6</c:f>
              <c:numCache>
                <c:formatCode>General</c:formatCode>
                <c:ptCount val="7"/>
                <c:pt idx="0">
                  <c:v>100.0</c:v>
                </c:pt>
                <c:pt idx="1">
                  <c:v>37.97162420642184</c:v>
                </c:pt>
                <c:pt idx="2">
                  <c:v>1.838293103173988</c:v>
                </c:pt>
                <c:pt idx="3">
                  <c:v>1.083209269397146</c:v>
                </c:pt>
                <c:pt idx="4">
                  <c:v>0.474913848201001</c:v>
                </c:pt>
                <c:pt idx="5">
                  <c:v>0.390623708648581</c:v>
                </c:pt>
                <c:pt idx="6">
                  <c:v>0.0890554392152541</c:v>
                </c:pt>
              </c:numCache>
            </c:numRef>
          </c:yVal>
          <c:smooth val="0"/>
        </c:ser>
        <c:ser>
          <c:idx val="4"/>
          <c:order val="4"/>
          <c:tx>
            <c:strRef>
              <c:f>'Glucose assay data'!$A$7</c:f>
              <c:strCache>
                <c:ptCount val="1"/>
                <c:pt idx="0">
                  <c:v>adh1.ymk23</c:v>
                </c:pt>
              </c:strCache>
            </c:strRef>
          </c:tx>
          <c:spPr>
            <a:ln w="12700"/>
          </c:spPr>
          <c:marker>
            <c:symbol val="star"/>
            <c:size val="3"/>
          </c:marker>
          <c:errBars>
            <c:errDir val="y"/>
            <c:errBarType val="both"/>
            <c:errValType val="cust"/>
            <c:noEndCap val="0"/>
            <c:plus>
              <c:numRef>
                <c:f>'Glucose assay data'!$B$15:$I$15</c:f>
                <c:numCache>
                  <c:formatCode>General</c:formatCode>
                  <c:ptCount val="8"/>
                  <c:pt idx="0">
                    <c:v>0.381420334121807</c:v>
                  </c:pt>
                  <c:pt idx="1">
                    <c:v>1.40601446466293</c:v>
                  </c:pt>
                  <c:pt idx="2">
                    <c:v>0.817225598155086</c:v>
                  </c:pt>
                  <c:pt idx="3">
                    <c:v>1.909110780602789</c:v>
                  </c:pt>
                  <c:pt idx="4">
                    <c:v>0.185606025130744</c:v>
                  </c:pt>
                  <c:pt idx="5">
                    <c:v>0.0588230544363313</c:v>
                  </c:pt>
                  <c:pt idx="6">
                    <c:v>0.0647961664123271</c:v>
                  </c:pt>
                </c:numCache>
              </c:numRef>
            </c:plus>
            <c:minus>
              <c:numRef>
                <c:f>'Glucose assay data'!$B$15:$H$15</c:f>
                <c:numCache>
                  <c:formatCode>General</c:formatCode>
                  <c:ptCount val="7"/>
                  <c:pt idx="0">
                    <c:v>0.381420334121807</c:v>
                  </c:pt>
                  <c:pt idx="1">
                    <c:v>1.40601446466293</c:v>
                  </c:pt>
                  <c:pt idx="2">
                    <c:v>0.817225598155086</c:v>
                  </c:pt>
                  <c:pt idx="3">
                    <c:v>1.909110780602789</c:v>
                  </c:pt>
                  <c:pt idx="4">
                    <c:v>0.185606025130744</c:v>
                  </c:pt>
                  <c:pt idx="5">
                    <c:v>0.0588230544363313</c:v>
                  </c:pt>
                  <c:pt idx="6">
                    <c:v>0.0647961664123271</c:v>
                  </c:pt>
                </c:numCache>
              </c:numRef>
            </c:minus>
          </c:errBars>
          <c:xVal>
            <c:numRef>
              <c:f>'Glucose assay data'!$B$2:$H$2</c:f>
              <c:numCache>
                <c:formatCode>General</c:formatCode>
                <c:ptCount val="7"/>
                <c:pt idx="0">
                  <c:v>0.0</c:v>
                </c:pt>
                <c:pt idx="1">
                  <c:v>2.0</c:v>
                </c:pt>
                <c:pt idx="2">
                  <c:v>4.0</c:v>
                </c:pt>
                <c:pt idx="3">
                  <c:v>7.0</c:v>
                </c:pt>
                <c:pt idx="4">
                  <c:v>9.0</c:v>
                </c:pt>
                <c:pt idx="5">
                  <c:v>11.0</c:v>
                </c:pt>
                <c:pt idx="6">
                  <c:v>21.0</c:v>
                </c:pt>
              </c:numCache>
            </c:numRef>
          </c:xVal>
          <c:yVal>
            <c:numRef>
              <c:f>'Glucose assay data'!$B$7:$H$7</c:f>
              <c:numCache>
                <c:formatCode>General</c:formatCode>
                <c:ptCount val="7"/>
                <c:pt idx="0">
                  <c:v>100.0</c:v>
                </c:pt>
                <c:pt idx="1">
                  <c:v>67.72991189261101</c:v>
                </c:pt>
                <c:pt idx="2">
                  <c:v>25.25724067059551</c:v>
                </c:pt>
                <c:pt idx="3">
                  <c:v>15.98334581587725</c:v>
                </c:pt>
                <c:pt idx="4">
                  <c:v>9.7025864741259</c:v>
                </c:pt>
                <c:pt idx="5">
                  <c:v>9.516173687711037</c:v>
                </c:pt>
                <c:pt idx="6">
                  <c:v>11.49811780336581</c:v>
                </c:pt>
              </c:numCache>
            </c:numRef>
          </c:yVal>
          <c:smooth val="0"/>
        </c:ser>
        <c:ser>
          <c:idx val="5"/>
          <c:order val="5"/>
          <c:tx>
            <c:strRef>
              <c:f>'Glucose assay data'!$A$8</c:f>
              <c:strCache>
                <c:ptCount val="1"/>
                <c:pt idx="0">
                  <c:v>adh1.BUTR+5g</c:v>
                </c:pt>
              </c:strCache>
            </c:strRef>
          </c:tx>
          <c:spPr>
            <a:ln w="12700"/>
          </c:spPr>
          <c:marker>
            <c:symbol val="circle"/>
            <c:size val="3"/>
          </c:marker>
          <c:errBars>
            <c:errDir val="y"/>
            <c:errBarType val="both"/>
            <c:errValType val="cust"/>
            <c:noEndCap val="0"/>
            <c:plus>
              <c:numRef>
                <c:f>'Glucose assay data'!$B$16:$H$16</c:f>
                <c:numCache>
                  <c:formatCode>General</c:formatCode>
                  <c:ptCount val="7"/>
                  <c:pt idx="0">
                    <c:v>0.376017970687374</c:v>
                  </c:pt>
                  <c:pt idx="1">
                    <c:v>0.696488365218368</c:v>
                  </c:pt>
                  <c:pt idx="2">
                    <c:v>1.086942866226244</c:v>
                  </c:pt>
                  <c:pt idx="3">
                    <c:v>0.172597789701976</c:v>
                  </c:pt>
                  <c:pt idx="4">
                    <c:v>0.0532804204307428</c:v>
                  </c:pt>
                  <c:pt idx="5">
                    <c:v>0.16829471367068</c:v>
                  </c:pt>
                  <c:pt idx="6">
                    <c:v>0.0664844226326128</c:v>
                  </c:pt>
                </c:numCache>
              </c:numRef>
            </c:plus>
            <c:minus>
              <c:numRef>
                <c:f>'Glucose assay data'!$B$16:$H$16</c:f>
                <c:numCache>
                  <c:formatCode>General</c:formatCode>
                  <c:ptCount val="7"/>
                  <c:pt idx="0">
                    <c:v>0.376017970687374</c:v>
                  </c:pt>
                  <c:pt idx="1">
                    <c:v>0.696488365218368</c:v>
                  </c:pt>
                  <c:pt idx="2">
                    <c:v>1.086942866226244</c:v>
                  </c:pt>
                  <c:pt idx="3">
                    <c:v>0.172597789701976</c:v>
                  </c:pt>
                  <c:pt idx="4">
                    <c:v>0.0532804204307428</c:v>
                  </c:pt>
                  <c:pt idx="5">
                    <c:v>0.16829471367068</c:v>
                  </c:pt>
                  <c:pt idx="6">
                    <c:v>0.0664844226326128</c:v>
                  </c:pt>
                </c:numCache>
              </c:numRef>
            </c:minus>
          </c:errBars>
          <c:xVal>
            <c:numRef>
              <c:f>'Glucose assay data'!$B$2:$H$2</c:f>
              <c:numCache>
                <c:formatCode>General</c:formatCode>
                <c:ptCount val="7"/>
                <c:pt idx="0">
                  <c:v>0.0</c:v>
                </c:pt>
                <c:pt idx="1">
                  <c:v>2.0</c:v>
                </c:pt>
                <c:pt idx="2">
                  <c:v>4.0</c:v>
                </c:pt>
                <c:pt idx="3">
                  <c:v>7.0</c:v>
                </c:pt>
                <c:pt idx="4">
                  <c:v>9.0</c:v>
                </c:pt>
                <c:pt idx="5">
                  <c:v>11.0</c:v>
                </c:pt>
                <c:pt idx="6">
                  <c:v>21.0</c:v>
                </c:pt>
              </c:numCache>
            </c:numRef>
          </c:xVal>
          <c:yVal>
            <c:numRef>
              <c:f>'Glucose assay data'!$B$8:$H$8</c:f>
              <c:numCache>
                <c:formatCode>General</c:formatCode>
                <c:ptCount val="7"/>
                <c:pt idx="0">
                  <c:v>100.0</c:v>
                </c:pt>
                <c:pt idx="1">
                  <c:v>42.55260203668659</c:v>
                </c:pt>
                <c:pt idx="2">
                  <c:v>5.687576619319196</c:v>
                </c:pt>
                <c:pt idx="3">
                  <c:v>0.884403275360107</c:v>
                </c:pt>
                <c:pt idx="4">
                  <c:v>0.58108462886387</c:v>
                </c:pt>
                <c:pt idx="5">
                  <c:v>0.987690365296051</c:v>
                </c:pt>
                <c:pt idx="6">
                  <c:v>0.365286694708878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086965896"/>
        <c:axId val="-2086938408"/>
      </c:scatterChart>
      <c:valAx>
        <c:axId val="-2086965896"/>
        <c:scaling>
          <c:orientation val="minMax"/>
          <c:max val="21.0"/>
          <c:min val="0.0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-2086938408"/>
        <c:crosses val="autoZero"/>
        <c:crossBetween val="midCat"/>
        <c:majorUnit val="3.0"/>
        <c:minorUnit val="0.6"/>
      </c:valAx>
      <c:valAx>
        <c:axId val="-2086938408"/>
        <c:scaling>
          <c:orientation val="minMax"/>
          <c:max val="100.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-2086965896"/>
        <c:crosses val="autoZero"/>
        <c:crossBetween val="midCat"/>
      </c:valAx>
    </c:plotArea>
    <c:plotVisOnly val="1"/>
    <c:dispBlanksAs val="gap"/>
    <c:showDLblsOverMax val="0"/>
  </c:chart>
  <c:externalData r:id="rId2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24236017834861"/>
          <c:y val="0.14750167523216"/>
          <c:w val="0.560208369610218"/>
          <c:h val="0.652451159433211"/>
        </c:manualLayout>
      </c:layout>
      <c:lineChart>
        <c:grouping val="standard"/>
        <c:varyColors val="0"/>
        <c:ser>
          <c:idx val="0"/>
          <c:order val="0"/>
          <c:tx>
            <c:strRef>
              <c:f>'Reems - growth rate data'!$B$7</c:f>
              <c:strCache>
                <c:ptCount val="1"/>
                <c:pt idx="0">
                  <c:v>BUTR+5g</c:v>
                </c:pt>
              </c:strCache>
            </c:strRef>
          </c:tx>
          <c:spPr>
            <a:ln w="12700"/>
          </c:spPr>
          <c:marker>
            <c:symbol val="diamond"/>
            <c:size val="3"/>
          </c:marker>
          <c:errBars>
            <c:errDir val="y"/>
            <c:errBarType val="both"/>
            <c:errValType val="cust"/>
            <c:noEndCap val="0"/>
            <c:plus>
              <c:numRef>
                <c:f>'Reems - growth rate data'!$C$19:$K$19</c:f>
                <c:numCache>
                  <c:formatCode>General</c:formatCode>
                  <c:ptCount val="9"/>
                  <c:pt idx="0">
                    <c:v>0.0126622799421484</c:v>
                  </c:pt>
                  <c:pt idx="1">
                    <c:v>0.141</c:v>
                  </c:pt>
                  <c:pt idx="2">
                    <c:v>0.24</c:v>
                  </c:pt>
                  <c:pt idx="3">
                    <c:v>0.055</c:v>
                  </c:pt>
                  <c:pt idx="4">
                    <c:v>0.23</c:v>
                  </c:pt>
                  <c:pt idx="5">
                    <c:v>0.0433128156554155</c:v>
                  </c:pt>
                  <c:pt idx="6">
                    <c:v>0.0427823951332009</c:v>
                  </c:pt>
                  <c:pt idx="7">
                    <c:v>0.031224989991992</c:v>
                  </c:pt>
                  <c:pt idx="8">
                    <c:v>0.0334713808100791</c:v>
                  </c:pt>
                </c:numCache>
              </c:numRef>
            </c:plus>
            <c:minus>
              <c:numRef>
                <c:f>'Reems - growth rate data'!$C$19:$K$19</c:f>
                <c:numCache>
                  <c:formatCode>General</c:formatCode>
                  <c:ptCount val="9"/>
                  <c:pt idx="0">
                    <c:v>0.0126622799421484</c:v>
                  </c:pt>
                  <c:pt idx="1">
                    <c:v>0.141</c:v>
                  </c:pt>
                  <c:pt idx="2">
                    <c:v>0.24</c:v>
                  </c:pt>
                  <c:pt idx="3">
                    <c:v>0.055</c:v>
                  </c:pt>
                  <c:pt idx="4">
                    <c:v>0.23</c:v>
                  </c:pt>
                  <c:pt idx="5">
                    <c:v>0.0433128156554155</c:v>
                  </c:pt>
                  <c:pt idx="6">
                    <c:v>0.0427823951332009</c:v>
                  </c:pt>
                  <c:pt idx="7">
                    <c:v>0.031224989991992</c:v>
                  </c:pt>
                  <c:pt idx="8">
                    <c:v>0.0334713808100791</c:v>
                  </c:pt>
                </c:numCache>
              </c:numRef>
            </c:minus>
          </c:errBars>
          <c:cat>
            <c:numRef>
              <c:f>'Reems - growth rate data'!$C$6:$K$6</c:f>
              <c:numCache>
                <c:formatCode>General</c:formatCode>
                <c:ptCount val="9"/>
                <c:pt idx="0">
                  <c:v>0.0</c:v>
                </c:pt>
                <c:pt idx="1">
                  <c:v>4.0</c:v>
                </c:pt>
                <c:pt idx="2">
                  <c:v>7.0</c:v>
                </c:pt>
                <c:pt idx="3">
                  <c:v>9.0</c:v>
                </c:pt>
                <c:pt idx="4">
                  <c:v>11.0</c:v>
                </c:pt>
                <c:pt idx="5">
                  <c:v>13.0</c:v>
                </c:pt>
                <c:pt idx="6">
                  <c:v>15.0</c:v>
                </c:pt>
                <c:pt idx="7">
                  <c:v>17.0</c:v>
                </c:pt>
                <c:pt idx="8">
                  <c:v>21.0</c:v>
                </c:pt>
              </c:numCache>
            </c:numRef>
          </c:cat>
          <c:val>
            <c:numRef>
              <c:f>'Reems - growth rate data'!$C$7:$K$7</c:f>
              <c:numCache>
                <c:formatCode>General</c:formatCode>
                <c:ptCount val="9"/>
                <c:pt idx="0">
                  <c:v>0.136</c:v>
                </c:pt>
                <c:pt idx="1">
                  <c:v>3.39</c:v>
                </c:pt>
                <c:pt idx="2">
                  <c:v>2.48</c:v>
                </c:pt>
                <c:pt idx="3">
                  <c:v>2.3</c:v>
                </c:pt>
                <c:pt idx="4">
                  <c:v>2.2</c:v>
                </c:pt>
                <c:pt idx="5">
                  <c:v>2.18</c:v>
                </c:pt>
                <c:pt idx="6">
                  <c:v>2.1</c:v>
                </c:pt>
                <c:pt idx="7">
                  <c:v>2.07</c:v>
                </c:pt>
                <c:pt idx="8">
                  <c:v>1.84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'Reems - growth rate data'!$B$8</c:f>
              <c:strCache>
                <c:ptCount val="1"/>
                <c:pt idx="0">
                  <c:v>BUT S+ 5g</c:v>
                </c:pt>
              </c:strCache>
            </c:strRef>
          </c:tx>
          <c:spPr>
            <a:ln w="12700"/>
          </c:spPr>
          <c:marker>
            <c:symbol val="square"/>
            <c:size val="3"/>
          </c:marker>
          <c:errBars>
            <c:errDir val="y"/>
            <c:errBarType val="both"/>
            <c:errValType val="cust"/>
            <c:noEndCap val="0"/>
            <c:plus>
              <c:numRef>
                <c:f>'Reems - growth rate data'!$C$20:$K$20</c:f>
                <c:numCache>
                  <c:formatCode>General</c:formatCode>
                  <c:ptCount val="9"/>
                  <c:pt idx="0">
                    <c:v>0.00929157324317757</c:v>
                  </c:pt>
                  <c:pt idx="1">
                    <c:v>0.170391705588427</c:v>
                  </c:pt>
                  <c:pt idx="2">
                    <c:v>0.21</c:v>
                  </c:pt>
                  <c:pt idx="3">
                    <c:v>0.34</c:v>
                  </c:pt>
                  <c:pt idx="4">
                    <c:v>0.45</c:v>
                  </c:pt>
                  <c:pt idx="5">
                    <c:v>0.154862304429882</c:v>
                  </c:pt>
                  <c:pt idx="6">
                    <c:v>0.153004357236431</c:v>
                  </c:pt>
                  <c:pt idx="7">
                    <c:v>0.14871449156017</c:v>
                  </c:pt>
                  <c:pt idx="8">
                    <c:v>0.140385184403483</c:v>
                  </c:pt>
                </c:numCache>
              </c:numRef>
            </c:plus>
            <c:minus>
              <c:numRef>
                <c:f>'Reems - growth rate data'!$C$20:$K$20</c:f>
                <c:numCache>
                  <c:formatCode>General</c:formatCode>
                  <c:ptCount val="9"/>
                  <c:pt idx="0">
                    <c:v>0.00929157324317757</c:v>
                  </c:pt>
                  <c:pt idx="1">
                    <c:v>0.170391705588427</c:v>
                  </c:pt>
                  <c:pt idx="2">
                    <c:v>0.21</c:v>
                  </c:pt>
                  <c:pt idx="3">
                    <c:v>0.34</c:v>
                  </c:pt>
                  <c:pt idx="4">
                    <c:v>0.45</c:v>
                  </c:pt>
                  <c:pt idx="5">
                    <c:v>0.154862304429882</c:v>
                  </c:pt>
                  <c:pt idx="6">
                    <c:v>0.153004357236431</c:v>
                  </c:pt>
                  <c:pt idx="7">
                    <c:v>0.14871449156017</c:v>
                  </c:pt>
                  <c:pt idx="8">
                    <c:v>0.140385184403483</c:v>
                  </c:pt>
                </c:numCache>
              </c:numRef>
            </c:minus>
          </c:errBars>
          <c:cat>
            <c:numRef>
              <c:f>'Reems - growth rate data'!$C$6:$K$6</c:f>
              <c:numCache>
                <c:formatCode>General</c:formatCode>
                <c:ptCount val="9"/>
                <c:pt idx="0">
                  <c:v>0.0</c:v>
                </c:pt>
                <c:pt idx="1">
                  <c:v>4.0</c:v>
                </c:pt>
                <c:pt idx="2">
                  <c:v>7.0</c:v>
                </c:pt>
                <c:pt idx="3">
                  <c:v>9.0</c:v>
                </c:pt>
                <c:pt idx="4">
                  <c:v>11.0</c:v>
                </c:pt>
                <c:pt idx="5">
                  <c:v>13.0</c:v>
                </c:pt>
                <c:pt idx="6">
                  <c:v>15.0</c:v>
                </c:pt>
                <c:pt idx="7">
                  <c:v>17.0</c:v>
                </c:pt>
                <c:pt idx="8">
                  <c:v>21.0</c:v>
                </c:pt>
              </c:numCache>
            </c:numRef>
          </c:cat>
          <c:val>
            <c:numRef>
              <c:f>'Reems - growth rate data'!$C$8:$K$8</c:f>
              <c:numCache>
                <c:formatCode>General</c:formatCode>
                <c:ptCount val="9"/>
                <c:pt idx="0">
                  <c:v>0.127</c:v>
                </c:pt>
                <c:pt idx="1">
                  <c:v>3.54</c:v>
                </c:pt>
                <c:pt idx="2">
                  <c:v>2.71</c:v>
                </c:pt>
                <c:pt idx="3">
                  <c:v>2.6</c:v>
                </c:pt>
                <c:pt idx="4">
                  <c:v>2.52</c:v>
                </c:pt>
                <c:pt idx="5">
                  <c:v>2.17</c:v>
                </c:pt>
                <c:pt idx="6">
                  <c:v>2.01</c:v>
                </c:pt>
                <c:pt idx="7">
                  <c:v>2.09</c:v>
                </c:pt>
                <c:pt idx="8">
                  <c:v>1.89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'Reems - growth rate data'!$B$9</c:f>
              <c:strCache>
                <c:ptCount val="1"/>
                <c:pt idx="0">
                  <c:v>adh1.ymk23</c:v>
                </c:pt>
              </c:strCache>
            </c:strRef>
          </c:tx>
          <c:spPr>
            <a:ln w="12700"/>
          </c:spPr>
          <c:marker>
            <c:symbol val="triangle"/>
            <c:size val="3"/>
          </c:marker>
          <c:errBars>
            <c:errDir val="y"/>
            <c:errBarType val="both"/>
            <c:errValType val="cust"/>
            <c:noEndCap val="0"/>
            <c:plus>
              <c:numRef>
                <c:f>'Reems - growth rate data'!$C$21:$K$21</c:f>
                <c:numCache>
                  <c:formatCode>General</c:formatCode>
                  <c:ptCount val="9"/>
                  <c:pt idx="0">
                    <c:v>0.00680685928555405</c:v>
                  </c:pt>
                  <c:pt idx="1">
                    <c:v>0.0395516539898564</c:v>
                  </c:pt>
                  <c:pt idx="2">
                    <c:v>0.0148436293854749</c:v>
                  </c:pt>
                  <c:pt idx="3">
                    <c:v>0.0123423390543824</c:v>
                  </c:pt>
                  <c:pt idx="4">
                    <c:v>0.0109696551146029</c:v>
                  </c:pt>
                  <c:pt idx="5">
                    <c:v>0.0122202018532156</c:v>
                  </c:pt>
                  <c:pt idx="6">
                    <c:v>0.0155349069303081</c:v>
                  </c:pt>
                  <c:pt idx="7">
                    <c:v>0.0115902257671425</c:v>
                  </c:pt>
                  <c:pt idx="8">
                    <c:v>0.0170977581376427</c:v>
                  </c:pt>
                </c:numCache>
              </c:numRef>
            </c:plus>
            <c:minus>
              <c:numRef>
                <c:f>'Reems - growth rate data'!$C$21:$K$21</c:f>
                <c:numCache>
                  <c:formatCode>General</c:formatCode>
                  <c:ptCount val="9"/>
                  <c:pt idx="0">
                    <c:v>0.00680685928555405</c:v>
                  </c:pt>
                  <c:pt idx="1">
                    <c:v>0.0395516539898564</c:v>
                  </c:pt>
                  <c:pt idx="2">
                    <c:v>0.0148436293854749</c:v>
                  </c:pt>
                  <c:pt idx="3">
                    <c:v>0.0123423390543824</c:v>
                  </c:pt>
                  <c:pt idx="4">
                    <c:v>0.0109696551146029</c:v>
                  </c:pt>
                  <c:pt idx="5">
                    <c:v>0.0122202018532156</c:v>
                  </c:pt>
                  <c:pt idx="6">
                    <c:v>0.0155349069303081</c:v>
                  </c:pt>
                  <c:pt idx="7">
                    <c:v>0.0115902257671425</c:v>
                  </c:pt>
                  <c:pt idx="8">
                    <c:v>0.0170977581376427</c:v>
                  </c:pt>
                </c:numCache>
              </c:numRef>
            </c:minus>
          </c:errBars>
          <c:cat>
            <c:numRef>
              <c:f>'Reems - growth rate data'!$C$6:$K$6</c:f>
              <c:numCache>
                <c:formatCode>General</c:formatCode>
                <c:ptCount val="9"/>
                <c:pt idx="0">
                  <c:v>0.0</c:v>
                </c:pt>
                <c:pt idx="1">
                  <c:v>4.0</c:v>
                </c:pt>
                <c:pt idx="2">
                  <c:v>7.0</c:v>
                </c:pt>
                <c:pt idx="3">
                  <c:v>9.0</c:v>
                </c:pt>
                <c:pt idx="4">
                  <c:v>11.0</c:v>
                </c:pt>
                <c:pt idx="5">
                  <c:v>13.0</c:v>
                </c:pt>
                <c:pt idx="6">
                  <c:v>15.0</c:v>
                </c:pt>
                <c:pt idx="7">
                  <c:v>17.0</c:v>
                </c:pt>
                <c:pt idx="8">
                  <c:v>21.0</c:v>
                </c:pt>
              </c:numCache>
            </c:numRef>
          </c:cat>
          <c:val>
            <c:numRef>
              <c:f>'Reems - growth rate data'!$C$9:$K$9</c:f>
              <c:numCache>
                <c:formatCode>General</c:formatCode>
                <c:ptCount val="9"/>
                <c:pt idx="0">
                  <c:v>0.131333333333333</c:v>
                </c:pt>
                <c:pt idx="1">
                  <c:v>0.193333333333333</c:v>
                </c:pt>
                <c:pt idx="2">
                  <c:v>0.160666666666667</c:v>
                </c:pt>
                <c:pt idx="3">
                  <c:v>0.160333333333333</c:v>
                </c:pt>
                <c:pt idx="4">
                  <c:v>0.147666666666667</c:v>
                </c:pt>
                <c:pt idx="5">
                  <c:v>0.136666666666667</c:v>
                </c:pt>
                <c:pt idx="6">
                  <c:v>0.142666666666667</c:v>
                </c:pt>
                <c:pt idx="7">
                  <c:v>0.139333333333333</c:v>
                </c:pt>
                <c:pt idx="8">
                  <c:v>0.122333333333333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'Reems - growth rate data'!$B$10</c:f>
              <c:strCache>
                <c:ptCount val="1"/>
                <c:pt idx="0">
                  <c:v>adh1.BUTR+5g</c:v>
                </c:pt>
              </c:strCache>
            </c:strRef>
          </c:tx>
          <c:spPr>
            <a:ln w="12700"/>
          </c:spPr>
          <c:marker>
            <c:symbol val="x"/>
            <c:size val="3"/>
          </c:marker>
          <c:errBars>
            <c:errDir val="y"/>
            <c:errBarType val="both"/>
            <c:errValType val="cust"/>
            <c:noEndCap val="0"/>
            <c:plus>
              <c:numRef>
                <c:f>'Reems - growth rate data'!$C$22:$K$22</c:f>
                <c:numCache>
                  <c:formatCode>General</c:formatCode>
                  <c:ptCount val="9"/>
                  <c:pt idx="0">
                    <c:v>0.0127671453348037</c:v>
                  </c:pt>
                  <c:pt idx="1">
                    <c:v>0.061133733186624</c:v>
                  </c:pt>
                  <c:pt idx="2">
                    <c:v>0.0978229693545102</c:v>
                  </c:pt>
                  <c:pt idx="3">
                    <c:v>0.0927739187487513</c:v>
                  </c:pt>
                  <c:pt idx="4">
                    <c:v>0.0892767233568382</c:v>
                  </c:pt>
                  <c:pt idx="5">
                    <c:v>0.0902348786962855</c:v>
                  </c:pt>
                  <c:pt idx="6">
                    <c:v>0.0642105910267136</c:v>
                  </c:pt>
                  <c:pt idx="7">
                    <c:v>0.0570116947067296</c:v>
                  </c:pt>
                  <c:pt idx="8">
                    <c:v>0.0355715241918776</c:v>
                  </c:pt>
                </c:numCache>
              </c:numRef>
            </c:plus>
            <c:minus>
              <c:numRef>
                <c:f>'Reems - growth rate data'!$C$22:$K$22</c:f>
                <c:numCache>
                  <c:formatCode>General</c:formatCode>
                  <c:ptCount val="9"/>
                  <c:pt idx="0">
                    <c:v>0.0127671453348037</c:v>
                  </c:pt>
                  <c:pt idx="1">
                    <c:v>0.061133733186624</c:v>
                  </c:pt>
                  <c:pt idx="2">
                    <c:v>0.0978229693545102</c:v>
                  </c:pt>
                  <c:pt idx="3">
                    <c:v>0.0927739187487513</c:v>
                  </c:pt>
                  <c:pt idx="4">
                    <c:v>0.0892767233568382</c:v>
                  </c:pt>
                  <c:pt idx="5">
                    <c:v>0.0902348786962855</c:v>
                  </c:pt>
                  <c:pt idx="6">
                    <c:v>0.0642105910267136</c:v>
                  </c:pt>
                  <c:pt idx="7">
                    <c:v>0.0570116947067296</c:v>
                  </c:pt>
                  <c:pt idx="8">
                    <c:v>0.0355715241918776</c:v>
                  </c:pt>
                </c:numCache>
              </c:numRef>
            </c:minus>
          </c:errBars>
          <c:cat>
            <c:numRef>
              <c:f>'Reems - growth rate data'!$C$6:$K$6</c:f>
              <c:numCache>
                <c:formatCode>General</c:formatCode>
                <c:ptCount val="9"/>
                <c:pt idx="0">
                  <c:v>0.0</c:v>
                </c:pt>
                <c:pt idx="1">
                  <c:v>4.0</c:v>
                </c:pt>
                <c:pt idx="2">
                  <c:v>7.0</c:v>
                </c:pt>
                <c:pt idx="3">
                  <c:v>9.0</c:v>
                </c:pt>
                <c:pt idx="4">
                  <c:v>11.0</c:v>
                </c:pt>
                <c:pt idx="5">
                  <c:v>13.0</c:v>
                </c:pt>
                <c:pt idx="6">
                  <c:v>15.0</c:v>
                </c:pt>
                <c:pt idx="7">
                  <c:v>17.0</c:v>
                </c:pt>
                <c:pt idx="8">
                  <c:v>21.0</c:v>
                </c:pt>
              </c:numCache>
            </c:numRef>
          </c:cat>
          <c:val>
            <c:numRef>
              <c:f>'Reems - growth rate data'!$C$10:$K$10</c:f>
              <c:numCache>
                <c:formatCode>General</c:formatCode>
                <c:ptCount val="9"/>
                <c:pt idx="0">
                  <c:v>0.12</c:v>
                </c:pt>
                <c:pt idx="1">
                  <c:v>0.695333333333333</c:v>
                </c:pt>
                <c:pt idx="2">
                  <c:v>0.648666666666667</c:v>
                </c:pt>
                <c:pt idx="3">
                  <c:v>0.638</c:v>
                </c:pt>
                <c:pt idx="4">
                  <c:v>0.607333333333333</c:v>
                </c:pt>
                <c:pt idx="5">
                  <c:v>0.565333333333333</c:v>
                </c:pt>
                <c:pt idx="6">
                  <c:v>0.51</c:v>
                </c:pt>
                <c:pt idx="7">
                  <c:v>0.484666666666667</c:v>
                </c:pt>
                <c:pt idx="8">
                  <c:v>0.440666666666667</c:v>
                </c:pt>
              </c:numCache>
            </c:numRef>
          </c:val>
          <c:smooth val="0"/>
        </c:ser>
        <c:ser>
          <c:idx val="4"/>
          <c:order val="4"/>
          <c:tx>
            <c:strRef>
              <c:f>'Reems - growth rate data'!$B$11</c:f>
              <c:strCache>
                <c:ptCount val="1"/>
                <c:pt idx="0">
                  <c:v>adh1.ALD6.ACS2.BUTR+5g</c:v>
                </c:pt>
              </c:strCache>
            </c:strRef>
          </c:tx>
          <c:spPr>
            <a:ln w="12700"/>
          </c:spPr>
          <c:marker>
            <c:symbol val="star"/>
            <c:size val="3"/>
          </c:marker>
          <c:errBars>
            <c:errDir val="y"/>
            <c:errBarType val="both"/>
            <c:errValType val="cust"/>
            <c:noEndCap val="0"/>
            <c:plus>
              <c:numRef>
                <c:f>'Reems - growth rate data'!$C$23:$K$23</c:f>
                <c:numCache>
                  <c:formatCode>General</c:formatCode>
                  <c:ptCount val="9"/>
                  <c:pt idx="0">
                    <c:v>0.0126622799421484</c:v>
                  </c:pt>
                  <c:pt idx="1">
                    <c:v>0.0432935715012441</c:v>
                  </c:pt>
                  <c:pt idx="2">
                    <c:v>0.0381881307912987</c:v>
                  </c:pt>
                  <c:pt idx="3">
                    <c:v>0.0383014360044111</c:v>
                  </c:pt>
                  <c:pt idx="4">
                    <c:v>0.0398873413503582</c:v>
                  </c:pt>
                  <c:pt idx="5">
                    <c:v>0.0433128156554155</c:v>
                  </c:pt>
                  <c:pt idx="6">
                    <c:v>0.0427823951332009</c:v>
                  </c:pt>
                  <c:pt idx="7">
                    <c:v>0.031224989991992</c:v>
                  </c:pt>
                  <c:pt idx="8">
                    <c:v>0.0334713808100791</c:v>
                  </c:pt>
                </c:numCache>
              </c:numRef>
            </c:plus>
            <c:minus>
              <c:numRef>
                <c:f>'Reems - growth rate data'!$C$23:$K$23</c:f>
                <c:numCache>
                  <c:formatCode>General</c:formatCode>
                  <c:ptCount val="9"/>
                  <c:pt idx="0">
                    <c:v>0.0126622799421484</c:v>
                  </c:pt>
                  <c:pt idx="1">
                    <c:v>0.0432935715012441</c:v>
                  </c:pt>
                  <c:pt idx="2">
                    <c:v>0.0381881307912987</c:v>
                  </c:pt>
                  <c:pt idx="3">
                    <c:v>0.0383014360044111</c:v>
                  </c:pt>
                  <c:pt idx="4">
                    <c:v>0.0398873413503582</c:v>
                  </c:pt>
                  <c:pt idx="5">
                    <c:v>0.0433128156554155</c:v>
                  </c:pt>
                  <c:pt idx="6">
                    <c:v>0.0427823951332009</c:v>
                  </c:pt>
                  <c:pt idx="7">
                    <c:v>0.031224989991992</c:v>
                  </c:pt>
                  <c:pt idx="8">
                    <c:v>0.0334713808100791</c:v>
                  </c:pt>
                </c:numCache>
              </c:numRef>
            </c:minus>
          </c:errBars>
          <c:cat>
            <c:numRef>
              <c:f>'Reems - growth rate data'!$C$6:$K$6</c:f>
              <c:numCache>
                <c:formatCode>General</c:formatCode>
                <c:ptCount val="9"/>
                <c:pt idx="0">
                  <c:v>0.0</c:v>
                </c:pt>
                <c:pt idx="1">
                  <c:v>4.0</c:v>
                </c:pt>
                <c:pt idx="2">
                  <c:v>7.0</c:v>
                </c:pt>
                <c:pt idx="3">
                  <c:v>9.0</c:v>
                </c:pt>
                <c:pt idx="4">
                  <c:v>11.0</c:v>
                </c:pt>
                <c:pt idx="5">
                  <c:v>13.0</c:v>
                </c:pt>
                <c:pt idx="6">
                  <c:v>15.0</c:v>
                </c:pt>
                <c:pt idx="7">
                  <c:v>17.0</c:v>
                </c:pt>
                <c:pt idx="8">
                  <c:v>21.0</c:v>
                </c:pt>
              </c:numCache>
            </c:numRef>
          </c:cat>
          <c:val>
            <c:numRef>
              <c:f>'Reems - growth rate data'!$C$11:$K$11</c:f>
              <c:numCache>
                <c:formatCode>General</c:formatCode>
                <c:ptCount val="9"/>
                <c:pt idx="0">
                  <c:v>0.116666666666667</c:v>
                </c:pt>
                <c:pt idx="1">
                  <c:v>0.583666666666667</c:v>
                </c:pt>
                <c:pt idx="2">
                  <c:v>0.520333333333333</c:v>
                </c:pt>
                <c:pt idx="3">
                  <c:v>0.522</c:v>
                </c:pt>
                <c:pt idx="4">
                  <c:v>0.527</c:v>
                </c:pt>
                <c:pt idx="5">
                  <c:v>0.504</c:v>
                </c:pt>
                <c:pt idx="6">
                  <c:v>0.481666666666667</c:v>
                </c:pt>
                <c:pt idx="7">
                  <c:v>0.492</c:v>
                </c:pt>
                <c:pt idx="8">
                  <c:v>0.471333333333333</c:v>
                </c:pt>
              </c:numCache>
            </c:numRef>
          </c:val>
          <c:smooth val="0"/>
        </c:ser>
        <c:ser>
          <c:idx val="5"/>
          <c:order val="5"/>
          <c:tx>
            <c:strRef>
              <c:f>'Reems - growth rate data'!$B$12</c:f>
              <c:strCache>
                <c:ptCount val="1"/>
                <c:pt idx="0">
                  <c:v>adh1.ALD6.ACS2.BUTS+5g</c:v>
                </c:pt>
              </c:strCache>
            </c:strRef>
          </c:tx>
          <c:spPr>
            <a:ln w="12700"/>
          </c:spPr>
          <c:marker>
            <c:symbol val="circle"/>
            <c:size val="3"/>
          </c:marker>
          <c:errBars>
            <c:errDir val="y"/>
            <c:errBarType val="both"/>
            <c:errValType val="cust"/>
            <c:noEndCap val="0"/>
            <c:plus>
              <c:numRef>
                <c:f>'Reems - growth rate data'!$C$24:$K$24</c:f>
                <c:numCache>
                  <c:formatCode>General</c:formatCode>
                  <c:ptCount val="9"/>
                  <c:pt idx="0">
                    <c:v>0.00929157324317757</c:v>
                  </c:pt>
                  <c:pt idx="1">
                    <c:v>0.140535879167326</c:v>
                  </c:pt>
                  <c:pt idx="2">
                    <c:v>0.132500314465036</c:v>
                  </c:pt>
                  <c:pt idx="3">
                    <c:v>0.140684043160552</c:v>
                  </c:pt>
                  <c:pt idx="4">
                    <c:v>0.153493756659134</c:v>
                  </c:pt>
                  <c:pt idx="5">
                    <c:v>0.154862304429882</c:v>
                  </c:pt>
                  <c:pt idx="6">
                    <c:v>0.153004357236431</c:v>
                  </c:pt>
                  <c:pt idx="7">
                    <c:v>0.14871449156017</c:v>
                  </c:pt>
                  <c:pt idx="8">
                    <c:v>0.140385184403483</c:v>
                  </c:pt>
                </c:numCache>
              </c:numRef>
            </c:plus>
            <c:minus>
              <c:numRef>
                <c:f>'Reems - growth rate data'!$C$24:$K$24</c:f>
                <c:numCache>
                  <c:formatCode>General</c:formatCode>
                  <c:ptCount val="9"/>
                  <c:pt idx="0">
                    <c:v>0.00929157324317757</c:v>
                  </c:pt>
                  <c:pt idx="1">
                    <c:v>0.140535879167326</c:v>
                  </c:pt>
                  <c:pt idx="2">
                    <c:v>0.132500314465036</c:v>
                  </c:pt>
                  <c:pt idx="3">
                    <c:v>0.140684043160552</c:v>
                  </c:pt>
                  <c:pt idx="4">
                    <c:v>0.153493756659134</c:v>
                  </c:pt>
                  <c:pt idx="5">
                    <c:v>0.154862304429882</c:v>
                  </c:pt>
                  <c:pt idx="6">
                    <c:v>0.153004357236431</c:v>
                  </c:pt>
                  <c:pt idx="7">
                    <c:v>0.14871449156017</c:v>
                  </c:pt>
                  <c:pt idx="8">
                    <c:v>0.140385184403483</c:v>
                  </c:pt>
                </c:numCache>
              </c:numRef>
            </c:minus>
          </c:errBars>
          <c:cat>
            <c:numRef>
              <c:f>'Reems - growth rate data'!$C$6:$K$6</c:f>
              <c:numCache>
                <c:formatCode>General</c:formatCode>
                <c:ptCount val="9"/>
                <c:pt idx="0">
                  <c:v>0.0</c:v>
                </c:pt>
                <c:pt idx="1">
                  <c:v>4.0</c:v>
                </c:pt>
                <c:pt idx="2">
                  <c:v>7.0</c:v>
                </c:pt>
                <c:pt idx="3">
                  <c:v>9.0</c:v>
                </c:pt>
                <c:pt idx="4">
                  <c:v>11.0</c:v>
                </c:pt>
                <c:pt idx="5">
                  <c:v>13.0</c:v>
                </c:pt>
                <c:pt idx="6">
                  <c:v>15.0</c:v>
                </c:pt>
                <c:pt idx="7">
                  <c:v>17.0</c:v>
                </c:pt>
                <c:pt idx="8">
                  <c:v>21.0</c:v>
                </c:pt>
              </c:numCache>
            </c:numRef>
          </c:cat>
          <c:val>
            <c:numRef>
              <c:f>'Reems - growth rate data'!$C$12:$K$12</c:f>
              <c:numCache>
                <c:formatCode>General</c:formatCode>
                <c:ptCount val="9"/>
                <c:pt idx="0">
                  <c:v>0.122666666666667</c:v>
                </c:pt>
                <c:pt idx="1">
                  <c:v>0.545666666666667</c:v>
                </c:pt>
                <c:pt idx="2">
                  <c:v>0.500666666666667</c:v>
                </c:pt>
                <c:pt idx="3">
                  <c:v>0.489</c:v>
                </c:pt>
                <c:pt idx="4">
                  <c:v>0.468666666666667</c:v>
                </c:pt>
                <c:pt idx="5">
                  <c:v>0.459666666666667</c:v>
                </c:pt>
                <c:pt idx="6">
                  <c:v>0.457333333333333</c:v>
                </c:pt>
                <c:pt idx="7">
                  <c:v>0.453</c:v>
                </c:pt>
                <c:pt idx="8">
                  <c:v>0.418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-2082737800"/>
        <c:axId val="-2100652536"/>
      </c:lineChart>
      <c:dateAx>
        <c:axId val="-2082737800"/>
        <c:scaling>
          <c:orientation val="minMax"/>
          <c:max val="21.0"/>
          <c:min val="0.0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-2100652536"/>
        <c:crosses val="autoZero"/>
        <c:auto val="0"/>
        <c:lblOffset val="100"/>
        <c:baseTimeUnit val="days"/>
        <c:majorUnit val="3.0"/>
        <c:majorTimeUnit val="days"/>
        <c:minorUnit val="1.0"/>
        <c:minorTimeUnit val="days"/>
      </c:dateAx>
      <c:valAx>
        <c:axId val="-210065253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-2082737800"/>
        <c:crosses val="autoZero"/>
        <c:crossBetween val="midCat"/>
      </c:valAx>
    </c:plotArea>
    <c:plotVisOnly val="1"/>
    <c:dispBlanksAs val="gap"/>
    <c:showDLblsOverMax val="0"/>
  </c:chart>
  <c:externalData r:id="rId2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86816024219931"/>
          <c:y val="0.158275499046063"/>
          <c:w val="0.560208369610218"/>
          <c:h val="0.652451159433211"/>
        </c:manualLayout>
      </c:layout>
      <c:lineChart>
        <c:grouping val="standard"/>
        <c:varyColors val="0"/>
        <c:ser>
          <c:idx val="1"/>
          <c:order val="0"/>
          <c:tx>
            <c:strRef>
              <c:f>'Reems - growth rate data'!$B$8</c:f>
              <c:strCache>
                <c:ptCount val="1"/>
                <c:pt idx="0">
                  <c:v>BUT S+ 5g</c:v>
                </c:pt>
              </c:strCache>
            </c:strRef>
          </c:tx>
          <c:spPr>
            <a:ln w="12700"/>
          </c:spPr>
          <c:marker>
            <c:symbol val="square"/>
            <c:size val="3"/>
          </c:marker>
          <c:errBars>
            <c:errDir val="y"/>
            <c:errBarType val="both"/>
            <c:errValType val="cust"/>
            <c:noEndCap val="0"/>
            <c:plus>
              <c:numRef>
                <c:f>'Reems - growth rate data'!$C$20:$K$20</c:f>
                <c:numCache>
                  <c:formatCode>General</c:formatCode>
                  <c:ptCount val="9"/>
                  <c:pt idx="0">
                    <c:v>0.00929157324317757</c:v>
                  </c:pt>
                  <c:pt idx="1">
                    <c:v>0.170391705588427</c:v>
                  </c:pt>
                  <c:pt idx="2">
                    <c:v>0.21</c:v>
                  </c:pt>
                  <c:pt idx="3">
                    <c:v>0.34</c:v>
                  </c:pt>
                  <c:pt idx="4">
                    <c:v>0.45</c:v>
                  </c:pt>
                  <c:pt idx="5">
                    <c:v>0.154862304429882</c:v>
                  </c:pt>
                  <c:pt idx="6">
                    <c:v>0.153004357236431</c:v>
                  </c:pt>
                  <c:pt idx="7">
                    <c:v>0.14871449156017</c:v>
                  </c:pt>
                  <c:pt idx="8">
                    <c:v>0.140385184403483</c:v>
                  </c:pt>
                </c:numCache>
              </c:numRef>
            </c:plus>
            <c:minus>
              <c:numRef>
                <c:f>'Reems - growth rate data'!$C$20:$K$20</c:f>
                <c:numCache>
                  <c:formatCode>General</c:formatCode>
                  <c:ptCount val="9"/>
                  <c:pt idx="0">
                    <c:v>0.00929157324317757</c:v>
                  </c:pt>
                  <c:pt idx="1">
                    <c:v>0.170391705588427</c:v>
                  </c:pt>
                  <c:pt idx="2">
                    <c:v>0.21</c:v>
                  </c:pt>
                  <c:pt idx="3">
                    <c:v>0.34</c:v>
                  </c:pt>
                  <c:pt idx="4">
                    <c:v>0.45</c:v>
                  </c:pt>
                  <c:pt idx="5">
                    <c:v>0.154862304429882</c:v>
                  </c:pt>
                  <c:pt idx="6">
                    <c:v>0.153004357236431</c:v>
                  </c:pt>
                  <c:pt idx="7">
                    <c:v>0.14871449156017</c:v>
                  </c:pt>
                  <c:pt idx="8">
                    <c:v>0.140385184403483</c:v>
                  </c:pt>
                </c:numCache>
              </c:numRef>
            </c:minus>
          </c:errBars>
          <c:cat>
            <c:numRef>
              <c:f>'Reems - growth rate data'!$C$6:$K$6</c:f>
              <c:numCache>
                <c:formatCode>General</c:formatCode>
                <c:ptCount val="9"/>
                <c:pt idx="0">
                  <c:v>0.0</c:v>
                </c:pt>
                <c:pt idx="1">
                  <c:v>4.0</c:v>
                </c:pt>
                <c:pt idx="2">
                  <c:v>7.0</c:v>
                </c:pt>
                <c:pt idx="3">
                  <c:v>9.0</c:v>
                </c:pt>
                <c:pt idx="4">
                  <c:v>11.0</c:v>
                </c:pt>
                <c:pt idx="5">
                  <c:v>13.0</c:v>
                </c:pt>
                <c:pt idx="6">
                  <c:v>15.0</c:v>
                </c:pt>
                <c:pt idx="7">
                  <c:v>17.0</c:v>
                </c:pt>
                <c:pt idx="8">
                  <c:v>21.0</c:v>
                </c:pt>
              </c:numCache>
            </c:numRef>
          </c:cat>
          <c:val>
            <c:numRef>
              <c:f>'Reems - growth rate data'!$C$8:$K$8</c:f>
              <c:numCache>
                <c:formatCode>General</c:formatCode>
                <c:ptCount val="9"/>
                <c:pt idx="0">
                  <c:v>0.127</c:v>
                </c:pt>
                <c:pt idx="1">
                  <c:v>3.54</c:v>
                </c:pt>
                <c:pt idx="2">
                  <c:v>2.71</c:v>
                </c:pt>
                <c:pt idx="3">
                  <c:v>2.6</c:v>
                </c:pt>
                <c:pt idx="4">
                  <c:v>2.52</c:v>
                </c:pt>
                <c:pt idx="5">
                  <c:v>2.17</c:v>
                </c:pt>
                <c:pt idx="6">
                  <c:v>2.01</c:v>
                </c:pt>
                <c:pt idx="7">
                  <c:v>2.09</c:v>
                </c:pt>
                <c:pt idx="8">
                  <c:v>1.89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-2008192504"/>
        <c:axId val="-2087607176"/>
      </c:lineChart>
      <c:dateAx>
        <c:axId val="-2008192504"/>
        <c:scaling>
          <c:orientation val="minMax"/>
          <c:max val="21.0"/>
          <c:min val="0.0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-2087607176"/>
        <c:crosses val="autoZero"/>
        <c:auto val="0"/>
        <c:lblOffset val="100"/>
        <c:baseTimeUnit val="days"/>
        <c:majorUnit val="3.0"/>
        <c:majorTimeUnit val="days"/>
        <c:minorUnit val="1.0"/>
        <c:minorTimeUnit val="days"/>
      </c:dateAx>
      <c:valAx>
        <c:axId val="-2087607176"/>
        <c:scaling>
          <c:orientation val="minMax"/>
          <c:max val="4.0"/>
          <c:min val="0.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-2008192504"/>
        <c:crosses val="autoZero"/>
        <c:crossBetween val="midCat"/>
        <c:majorUnit val="1.0"/>
      </c:valAx>
    </c:plotArea>
    <c:plotVisOnly val="1"/>
    <c:dispBlanksAs val="gap"/>
    <c:showDLblsOverMax val="0"/>
  </c:chart>
  <c:externalData r:id="rId2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24299225944635"/>
          <c:y val="0.201370208152535"/>
          <c:w val="0.560208369610218"/>
          <c:h val="0.652451159433211"/>
        </c:manualLayout>
      </c:layout>
      <c:lineChart>
        <c:grouping val="standard"/>
        <c:varyColors val="0"/>
        <c:ser>
          <c:idx val="0"/>
          <c:order val="0"/>
          <c:tx>
            <c:strRef>
              <c:f>'Reems - growth rate data'!$B$7</c:f>
              <c:strCache>
                <c:ptCount val="1"/>
                <c:pt idx="0">
                  <c:v>BUTR+5g</c:v>
                </c:pt>
              </c:strCache>
            </c:strRef>
          </c:tx>
          <c:spPr>
            <a:ln w="12700"/>
          </c:spPr>
          <c:marker>
            <c:symbol val="diamond"/>
            <c:size val="4"/>
          </c:marker>
          <c:errBars>
            <c:errDir val="y"/>
            <c:errBarType val="both"/>
            <c:errValType val="cust"/>
            <c:noEndCap val="0"/>
            <c:plus>
              <c:numRef>
                <c:f>'Reems - growth rate data'!$C$19:$K$19</c:f>
                <c:numCache>
                  <c:formatCode>General</c:formatCode>
                  <c:ptCount val="9"/>
                  <c:pt idx="0">
                    <c:v>0.0126622799421484</c:v>
                  </c:pt>
                  <c:pt idx="1">
                    <c:v>0.141</c:v>
                  </c:pt>
                  <c:pt idx="2">
                    <c:v>0.24</c:v>
                  </c:pt>
                  <c:pt idx="3">
                    <c:v>0.055</c:v>
                  </c:pt>
                  <c:pt idx="4">
                    <c:v>0.23</c:v>
                  </c:pt>
                  <c:pt idx="5">
                    <c:v>0.0433128156554155</c:v>
                  </c:pt>
                  <c:pt idx="6">
                    <c:v>0.0427823951332009</c:v>
                  </c:pt>
                  <c:pt idx="7">
                    <c:v>0.031224989991992</c:v>
                  </c:pt>
                  <c:pt idx="8">
                    <c:v>0.0334713808100791</c:v>
                  </c:pt>
                </c:numCache>
              </c:numRef>
            </c:plus>
            <c:minus>
              <c:numRef>
                <c:f>'Reems - growth rate data'!$C$19:$K$19</c:f>
                <c:numCache>
                  <c:formatCode>General</c:formatCode>
                  <c:ptCount val="9"/>
                  <c:pt idx="0">
                    <c:v>0.0126622799421484</c:v>
                  </c:pt>
                  <c:pt idx="1">
                    <c:v>0.141</c:v>
                  </c:pt>
                  <c:pt idx="2">
                    <c:v>0.24</c:v>
                  </c:pt>
                  <c:pt idx="3">
                    <c:v>0.055</c:v>
                  </c:pt>
                  <c:pt idx="4">
                    <c:v>0.23</c:v>
                  </c:pt>
                  <c:pt idx="5">
                    <c:v>0.0433128156554155</c:v>
                  </c:pt>
                  <c:pt idx="6">
                    <c:v>0.0427823951332009</c:v>
                  </c:pt>
                  <c:pt idx="7">
                    <c:v>0.031224989991992</c:v>
                  </c:pt>
                  <c:pt idx="8">
                    <c:v>0.0334713808100791</c:v>
                  </c:pt>
                </c:numCache>
              </c:numRef>
            </c:minus>
          </c:errBars>
          <c:cat>
            <c:numRef>
              <c:f>'Reems - growth rate data'!$C$6:$K$6</c:f>
              <c:numCache>
                <c:formatCode>General</c:formatCode>
                <c:ptCount val="9"/>
                <c:pt idx="0">
                  <c:v>0.0</c:v>
                </c:pt>
                <c:pt idx="1">
                  <c:v>4.0</c:v>
                </c:pt>
                <c:pt idx="2">
                  <c:v>7.0</c:v>
                </c:pt>
                <c:pt idx="3">
                  <c:v>9.0</c:v>
                </c:pt>
                <c:pt idx="4">
                  <c:v>11.0</c:v>
                </c:pt>
                <c:pt idx="5">
                  <c:v>13.0</c:v>
                </c:pt>
                <c:pt idx="6">
                  <c:v>15.0</c:v>
                </c:pt>
                <c:pt idx="7">
                  <c:v>17.0</c:v>
                </c:pt>
                <c:pt idx="8">
                  <c:v>21.0</c:v>
                </c:pt>
              </c:numCache>
            </c:numRef>
          </c:cat>
          <c:val>
            <c:numRef>
              <c:f>'Reems - growth rate data'!$C$7:$K$7</c:f>
              <c:numCache>
                <c:formatCode>General</c:formatCode>
                <c:ptCount val="9"/>
                <c:pt idx="0">
                  <c:v>0.136</c:v>
                </c:pt>
                <c:pt idx="1">
                  <c:v>3.39</c:v>
                </c:pt>
                <c:pt idx="2">
                  <c:v>2.48</c:v>
                </c:pt>
                <c:pt idx="3">
                  <c:v>2.3</c:v>
                </c:pt>
                <c:pt idx="4">
                  <c:v>2.2</c:v>
                </c:pt>
                <c:pt idx="5">
                  <c:v>2.18</c:v>
                </c:pt>
                <c:pt idx="6">
                  <c:v>2.1</c:v>
                </c:pt>
                <c:pt idx="7">
                  <c:v>2.07</c:v>
                </c:pt>
                <c:pt idx="8">
                  <c:v>1.84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-2087165160"/>
        <c:axId val="-2083013736"/>
      </c:lineChart>
      <c:dateAx>
        <c:axId val="-208716516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-2083013736"/>
        <c:crosses val="autoZero"/>
        <c:auto val="0"/>
        <c:lblOffset val="100"/>
        <c:baseTimeUnit val="days"/>
        <c:majorUnit val="3.0"/>
        <c:majorTimeUnit val="days"/>
      </c:dateAx>
      <c:valAx>
        <c:axId val="-208301373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-2087165160"/>
        <c:crosses val="autoZero"/>
        <c:crossBetween val="midCat"/>
      </c:valAx>
    </c:plotArea>
    <c:plotVisOnly val="1"/>
    <c:dispBlanksAs val="gap"/>
    <c:showDLblsOverMax val="0"/>
  </c:chart>
  <c:externalData r:id="rId2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043B97-8879-44B7-AFDA-7239F923A6C5}" type="datetimeFigureOut">
              <a:rPr lang="en-GB" smtClean="0"/>
              <a:t>23/06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FD0F88-16F6-41F9-A118-15D0D263746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916412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043B97-8879-44B7-AFDA-7239F923A6C5}" type="datetimeFigureOut">
              <a:rPr lang="en-GB" smtClean="0"/>
              <a:t>23/06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FD0F88-16F6-41F9-A118-15D0D263746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918283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043B97-8879-44B7-AFDA-7239F923A6C5}" type="datetimeFigureOut">
              <a:rPr lang="en-GB" smtClean="0"/>
              <a:t>23/06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FD0F88-16F6-41F9-A118-15D0D263746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825243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043B97-8879-44B7-AFDA-7239F923A6C5}" type="datetimeFigureOut">
              <a:rPr lang="en-GB" smtClean="0"/>
              <a:t>23/06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FD0F88-16F6-41F9-A118-15D0D263746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460035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043B97-8879-44B7-AFDA-7239F923A6C5}" type="datetimeFigureOut">
              <a:rPr lang="en-GB" smtClean="0"/>
              <a:t>23/06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FD0F88-16F6-41F9-A118-15D0D263746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462423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043B97-8879-44B7-AFDA-7239F923A6C5}" type="datetimeFigureOut">
              <a:rPr lang="en-GB" smtClean="0"/>
              <a:t>23/06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FD0F88-16F6-41F9-A118-15D0D263746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618464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043B97-8879-44B7-AFDA-7239F923A6C5}" type="datetimeFigureOut">
              <a:rPr lang="en-GB" smtClean="0"/>
              <a:t>23/06/201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FD0F88-16F6-41F9-A118-15D0D263746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735665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043B97-8879-44B7-AFDA-7239F923A6C5}" type="datetimeFigureOut">
              <a:rPr lang="en-GB" smtClean="0"/>
              <a:t>23/06/201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FD0F88-16F6-41F9-A118-15D0D263746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00331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043B97-8879-44B7-AFDA-7239F923A6C5}" type="datetimeFigureOut">
              <a:rPr lang="en-GB" smtClean="0"/>
              <a:t>23/06/201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FD0F88-16F6-41F9-A118-15D0D263746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4948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043B97-8879-44B7-AFDA-7239F923A6C5}" type="datetimeFigureOut">
              <a:rPr lang="en-GB" smtClean="0"/>
              <a:t>23/06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FD0F88-16F6-41F9-A118-15D0D263746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306488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043B97-8879-44B7-AFDA-7239F923A6C5}" type="datetimeFigureOut">
              <a:rPr lang="en-GB" smtClean="0"/>
              <a:t>23/06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FD0F88-16F6-41F9-A118-15D0D263746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761409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043B97-8879-44B7-AFDA-7239F923A6C5}" type="datetimeFigureOut">
              <a:rPr lang="en-GB" smtClean="0"/>
              <a:t>23/06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FD0F88-16F6-41F9-A118-15D0D263746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623116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1" Type="http://schemas.openxmlformats.org/officeDocument/2006/relationships/chart" Target="../charts/chart10.xml"/><Relationship Id="rId12" Type="http://schemas.openxmlformats.org/officeDocument/2006/relationships/chart" Target="../charts/chart11.xml"/><Relationship Id="rId13" Type="http://schemas.openxmlformats.org/officeDocument/2006/relationships/chart" Target="../charts/chart12.xml"/><Relationship Id="rId14" Type="http://schemas.openxmlformats.org/officeDocument/2006/relationships/chart" Target="../charts/chart13.xml"/><Relationship Id="rId15" Type="http://schemas.openxmlformats.org/officeDocument/2006/relationships/chart" Target="../charts/chart14.xml"/><Relationship Id="rId16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2" Type="http://schemas.openxmlformats.org/officeDocument/2006/relationships/chart" Target="../charts/chart1.xml"/><Relationship Id="rId3" Type="http://schemas.openxmlformats.org/officeDocument/2006/relationships/chart" Target="../charts/chart2.xml"/><Relationship Id="rId4" Type="http://schemas.openxmlformats.org/officeDocument/2006/relationships/chart" Target="../charts/chart3.xml"/><Relationship Id="rId5" Type="http://schemas.openxmlformats.org/officeDocument/2006/relationships/chart" Target="../charts/chart4.xml"/><Relationship Id="rId6" Type="http://schemas.openxmlformats.org/officeDocument/2006/relationships/chart" Target="../charts/chart5.xml"/><Relationship Id="rId7" Type="http://schemas.openxmlformats.org/officeDocument/2006/relationships/chart" Target="../charts/chart6.xml"/><Relationship Id="rId8" Type="http://schemas.openxmlformats.org/officeDocument/2006/relationships/chart" Target="../charts/chart7.xml"/><Relationship Id="rId9" Type="http://schemas.openxmlformats.org/officeDocument/2006/relationships/chart" Target="../charts/chart8.xml"/><Relationship Id="rId10" Type="http://schemas.openxmlformats.org/officeDocument/2006/relationships/chart" Target="../charts/chart9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2" name="Chart 1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20221213"/>
              </p:ext>
            </p:extLst>
          </p:nvPr>
        </p:nvGraphicFramePr>
        <p:xfrm>
          <a:off x="1014160" y="3730014"/>
          <a:ext cx="2031896" cy="118068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9" name="Chart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10920708"/>
              </p:ext>
            </p:extLst>
          </p:nvPr>
        </p:nvGraphicFramePr>
        <p:xfrm>
          <a:off x="1013125" y="5772077"/>
          <a:ext cx="2031896" cy="11787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1" name="Chart 1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94862878"/>
              </p:ext>
            </p:extLst>
          </p:nvPr>
        </p:nvGraphicFramePr>
        <p:xfrm>
          <a:off x="1012469" y="4750850"/>
          <a:ext cx="2031896" cy="11787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7" name="Chart 1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3471654"/>
              </p:ext>
            </p:extLst>
          </p:nvPr>
        </p:nvGraphicFramePr>
        <p:xfrm>
          <a:off x="3107340" y="4672773"/>
          <a:ext cx="2021276" cy="118578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8" name="Chart 1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39928318"/>
              </p:ext>
            </p:extLst>
          </p:nvPr>
        </p:nvGraphicFramePr>
        <p:xfrm>
          <a:off x="3106079" y="5697144"/>
          <a:ext cx="2017786" cy="118578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0522423"/>
              </p:ext>
            </p:extLst>
          </p:nvPr>
        </p:nvGraphicFramePr>
        <p:xfrm>
          <a:off x="3110434" y="609192"/>
          <a:ext cx="2021276" cy="118578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36231654"/>
              </p:ext>
            </p:extLst>
          </p:nvPr>
        </p:nvGraphicFramePr>
        <p:xfrm>
          <a:off x="1003772" y="662337"/>
          <a:ext cx="2031896" cy="11787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60601204"/>
              </p:ext>
            </p:extLst>
          </p:nvPr>
        </p:nvGraphicFramePr>
        <p:xfrm>
          <a:off x="882202" y="1678314"/>
          <a:ext cx="2029403" cy="11787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98949867"/>
              </p:ext>
            </p:extLst>
          </p:nvPr>
        </p:nvGraphicFramePr>
        <p:xfrm>
          <a:off x="772466" y="2644806"/>
          <a:ext cx="2031896" cy="11787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aphicFrame>
        <p:nvGraphicFramePr>
          <p:cNvPr id="13" name="Chart 1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76473559"/>
              </p:ext>
            </p:extLst>
          </p:nvPr>
        </p:nvGraphicFramePr>
        <p:xfrm>
          <a:off x="2940772" y="1662695"/>
          <a:ext cx="2021276" cy="118578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graphicFrame>
        <p:nvGraphicFramePr>
          <p:cNvPr id="14" name="Chart 1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29020504"/>
              </p:ext>
            </p:extLst>
          </p:nvPr>
        </p:nvGraphicFramePr>
        <p:xfrm>
          <a:off x="3107824" y="2662100"/>
          <a:ext cx="2021276" cy="119337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graphicFrame>
        <p:nvGraphicFramePr>
          <p:cNvPr id="15" name="Chart 1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47767016"/>
              </p:ext>
            </p:extLst>
          </p:nvPr>
        </p:nvGraphicFramePr>
        <p:xfrm>
          <a:off x="3109672" y="3656227"/>
          <a:ext cx="2021276" cy="118578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3"/>
          </a:graphicData>
        </a:graphic>
      </p:graphicFrame>
      <p:grpSp>
        <p:nvGrpSpPr>
          <p:cNvPr id="19" name="Group 18"/>
          <p:cNvGrpSpPr/>
          <p:nvPr/>
        </p:nvGrpSpPr>
        <p:grpSpPr>
          <a:xfrm>
            <a:off x="1012001" y="6736413"/>
            <a:ext cx="4116928" cy="1256416"/>
            <a:chOff x="1012001" y="5020525"/>
            <a:chExt cx="4116928" cy="1256416"/>
          </a:xfrm>
        </p:grpSpPr>
        <p:graphicFrame>
          <p:nvGraphicFramePr>
            <p:cNvPr id="10" name="Chart 9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590427164"/>
                </p:ext>
              </p:extLst>
            </p:nvPr>
          </p:nvGraphicFramePr>
          <p:xfrm>
            <a:off x="1012001" y="5098142"/>
            <a:ext cx="2031896" cy="117879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4"/>
            </a:graphicData>
          </a:graphic>
        </p:graphicFrame>
        <p:graphicFrame>
          <p:nvGraphicFramePr>
            <p:cNvPr id="16" name="Chart 15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416714307"/>
                </p:ext>
              </p:extLst>
            </p:nvPr>
          </p:nvGraphicFramePr>
          <p:xfrm>
            <a:off x="3107653" y="5020525"/>
            <a:ext cx="2021276" cy="118578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5"/>
            </a:graphicData>
          </a:graphic>
        </p:graphicFrame>
      </p:grpSp>
      <p:sp>
        <p:nvSpPr>
          <p:cNvPr id="27" name="TextBox 26"/>
          <p:cNvSpPr txBox="1"/>
          <p:nvPr/>
        </p:nvSpPr>
        <p:spPr>
          <a:xfrm>
            <a:off x="1403645" y="520416"/>
            <a:ext cx="98046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/>
              <a:t>Growth (OD</a:t>
            </a:r>
            <a:r>
              <a:rPr lang="en-US" sz="1000" baseline="-25000"/>
              <a:t>600</a:t>
            </a:r>
            <a:r>
              <a:rPr lang="en-US" sz="1000"/>
              <a:t>)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3122622" y="520416"/>
            <a:ext cx="15086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/>
              <a:t>Glucose consumption (%) </a:t>
            </a:r>
          </a:p>
        </p:txBody>
      </p:sp>
      <p:pic>
        <p:nvPicPr>
          <p:cNvPr id="2" name="Picture 1" descr="Screen shot 2015-06-20 at 22.39.48.png"/>
          <p:cNvPicPr>
            <a:picLocks noChangeAspect="1"/>
          </p:cNvPicPr>
          <p:nvPr/>
        </p:nvPicPr>
        <p:blipFill rotWithShape="1"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77034"/>
          <a:stretch/>
        </p:blipFill>
        <p:spPr>
          <a:xfrm>
            <a:off x="4622800" y="768541"/>
            <a:ext cx="349999" cy="1427703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4885493" y="981665"/>
            <a:ext cx="47961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/>
              <a:t>B</a:t>
            </a:r>
            <a:r>
              <a:rPr lang="en-US" sz="900" baseline="30000"/>
              <a:t>R </a:t>
            </a:r>
            <a:r>
              <a:rPr lang="en-US" sz="900"/>
              <a:t>+5g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4885493" y="775753"/>
            <a:ext cx="47050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/>
              <a:t>B</a:t>
            </a:r>
            <a:r>
              <a:rPr lang="en-US" sz="900" baseline="30000"/>
              <a:t>S </a:t>
            </a:r>
            <a:r>
              <a:rPr lang="en-US" sz="900"/>
              <a:t>+5g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4885493" y="1434590"/>
            <a:ext cx="108234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i="1"/>
              <a:t>A6A2</a:t>
            </a:r>
            <a:r>
              <a:rPr lang="en-US" sz="900"/>
              <a:t> B</a:t>
            </a:r>
            <a:r>
              <a:rPr lang="en-US" sz="900" baseline="30000"/>
              <a:t>S </a:t>
            </a:r>
            <a:r>
              <a:rPr lang="en-US" sz="900" i="1"/>
              <a:t>adh1</a:t>
            </a:r>
            <a:r>
              <a:rPr lang="en-US" sz="900" i="1">
                <a:latin typeface="Symbol" charset="2"/>
                <a:cs typeface="Symbol" charset="2"/>
              </a:rPr>
              <a:t>D</a:t>
            </a:r>
            <a:r>
              <a:rPr lang="en-US" sz="900"/>
              <a:t> +5g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4885493" y="1212886"/>
            <a:ext cx="109450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i="1"/>
              <a:t>A6A2</a:t>
            </a:r>
            <a:r>
              <a:rPr lang="en-US" sz="900"/>
              <a:t> B</a:t>
            </a:r>
            <a:r>
              <a:rPr lang="en-US" sz="900" baseline="30000"/>
              <a:t>R </a:t>
            </a:r>
            <a:r>
              <a:rPr lang="en-US" sz="900" i="1"/>
              <a:t>adh1</a:t>
            </a:r>
            <a:r>
              <a:rPr lang="en-US" sz="900" i="1">
                <a:latin typeface="Symbol" charset="2"/>
                <a:cs typeface="Symbol" charset="2"/>
              </a:rPr>
              <a:t>D</a:t>
            </a:r>
            <a:r>
              <a:rPr lang="en-US" sz="900"/>
              <a:t> +5g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4889989" y="1653320"/>
            <a:ext cx="64581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/>
              <a:t>B</a:t>
            </a:r>
            <a:r>
              <a:rPr lang="en-US" sz="900" baseline="30000"/>
              <a:t>R </a:t>
            </a:r>
            <a:r>
              <a:rPr lang="en-US" sz="900" i="1"/>
              <a:t>adh1</a:t>
            </a:r>
            <a:r>
              <a:rPr lang="en-US" sz="900" i="1">
                <a:latin typeface="Symbol" charset="2"/>
                <a:cs typeface="Symbol" charset="2"/>
              </a:rPr>
              <a:t>D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4889989" y="1879757"/>
            <a:ext cx="84497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/>
              <a:t>B</a:t>
            </a:r>
            <a:r>
              <a:rPr lang="en-US" sz="900" baseline="30000"/>
              <a:t>R </a:t>
            </a:r>
            <a:r>
              <a:rPr lang="en-US" sz="900" i="1"/>
              <a:t>adh1</a:t>
            </a:r>
            <a:r>
              <a:rPr lang="en-US" sz="900" i="1">
                <a:latin typeface="Symbol" charset="2"/>
                <a:cs typeface="Symbol" charset="2"/>
              </a:rPr>
              <a:t>D </a:t>
            </a:r>
            <a:r>
              <a:rPr lang="en-US" sz="900"/>
              <a:t>+5g</a:t>
            </a:r>
            <a:endParaRPr lang="en-US" sz="900" i="1">
              <a:latin typeface="Symbol" charset="2"/>
              <a:cs typeface="Symbol" charset="2"/>
            </a:endParaRPr>
          </a:p>
        </p:txBody>
      </p:sp>
      <p:sp>
        <p:nvSpPr>
          <p:cNvPr id="30" name="Text Box 14"/>
          <p:cNvSpPr txBox="1">
            <a:spLocks noChangeArrowheads="1"/>
          </p:cNvSpPr>
          <p:nvPr/>
        </p:nvSpPr>
        <p:spPr bwMode="auto">
          <a:xfrm>
            <a:off x="965639" y="8170199"/>
            <a:ext cx="4940300" cy="6463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 algn="just">
              <a:defRPr/>
            </a:pPr>
            <a:r>
              <a:rPr lang="en-GB" sz="1200" dirty="0">
                <a:ea typeface="ＭＳ Ｐゴシック" charset="0"/>
                <a:cs typeface="+mn-cs"/>
              </a:rPr>
              <a:t>Figure S1. </a:t>
            </a:r>
            <a:r>
              <a:rPr lang="en-GB" sz="1200"/>
              <a:t>Growth (OD</a:t>
            </a:r>
            <a:r>
              <a:rPr lang="en-GB" sz="1200" baseline="-25000"/>
              <a:t>600</a:t>
            </a:r>
            <a:r>
              <a:rPr lang="en-GB" sz="1200"/>
              <a:t>) and glucose consumption (%) for the strains  indicated over 21 day anaerobic fermentations. Error bars are ±SEM from 3 biological repeats.</a:t>
            </a:r>
            <a:r>
              <a:rPr lang="en-GB" sz="1200">
                <a:effectLst/>
              </a:rPr>
              <a:t> </a:t>
            </a:r>
            <a:endParaRPr lang="en-GB" sz="1200" dirty="0">
              <a:ea typeface="ＭＳ Ｐゴシック" charset="0"/>
              <a:cs typeface="+mn-cs"/>
            </a:endParaRPr>
          </a:p>
        </p:txBody>
      </p:sp>
      <p:pic>
        <p:nvPicPr>
          <p:cNvPr id="31" name="Picture 30" descr="Screen shot 2015-06-20 at 22.39.48.png"/>
          <p:cNvPicPr>
            <a:picLocks noChangeAspect="1"/>
          </p:cNvPicPr>
          <p:nvPr/>
        </p:nvPicPr>
        <p:blipFill rotWithShape="1"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77034" b="68684"/>
          <a:stretch/>
        </p:blipFill>
        <p:spPr>
          <a:xfrm flipV="1">
            <a:off x="4614779" y="809539"/>
            <a:ext cx="349999" cy="44709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72881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10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1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1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1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1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5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6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7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8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9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1050</TotalTime>
  <Words>64</Words>
  <Application>Microsoft Macintosh PowerPoint</Application>
  <PresentationFormat>A4 Paper (210x297 mm)</PresentationFormat>
  <Paragraphs>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y of Manchester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indows User</dc:creator>
  <cp:lastModifiedBy>Mark Ashe</cp:lastModifiedBy>
  <cp:revision>23</cp:revision>
  <dcterms:created xsi:type="dcterms:W3CDTF">2015-06-19T13:29:14Z</dcterms:created>
  <dcterms:modified xsi:type="dcterms:W3CDTF">2015-06-23T10:10:20Z</dcterms:modified>
</cp:coreProperties>
</file>